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mf" ContentType="image/x-wm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480" r:id="rId2"/>
    <p:sldId id="472" r:id="rId3"/>
    <p:sldId id="405" r:id="rId4"/>
    <p:sldId id="479" r:id="rId5"/>
    <p:sldId id="478" r:id="rId6"/>
  </p:sldIdLst>
  <p:sldSz cx="9144000" cy="12192000"/>
  <p:notesSz cx="68580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576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iana Acevedo" initials="DA" lastIdx="8" clrIdx="0">
    <p:extLst>
      <p:ext uri="{19B8F6BF-5375-455C-9EA6-DF929625EA0E}">
        <p15:presenceInfo xmlns:p15="http://schemas.microsoft.com/office/powerpoint/2012/main" userId="6920d49dddd5082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F0D8BD"/>
    <a:srgbClr val="00CC00"/>
    <a:srgbClr val="0000FF"/>
    <a:srgbClr val="421A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6587" autoAdjust="0"/>
  </p:normalViewPr>
  <p:slideViewPr>
    <p:cSldViewPr>
      <p:cViewPr>
        <p:scale>
          <a:sx n="55" d="100"/>
          <a:sy n="55" d="100"/>
        </p:scale>
        <p:origin x="2064" y="624"/>
      </p:cViewPr>
      <p:guideLst>
        <p:guide orient="horz" pos="6576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PowerPoint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Chart%20in%20Microsoft%20PowerPoint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N$8:$N$11</c:f>
                <c:numCache>
                  <c:formatCode>General</c:formatCode>
                  <c:ptCount val="4"/>
                  <c:pt idx="0">
                    <c:v>2.1239677889420502E-3</c:v>
                  </c:pt>
                  <c:pt idx="1">
                    <c:v>1.8420677857537301E-3</c:v>
                  </c:pt>
                  <c:pt idx="2">
                    <c:v>1.081438756987658E-3</c:v>
                  </c:pt>
                  <c:pt idx="3">
                    <c:v>1.9914132725245299E-3</c:v>
                  </c:pt>
                </c:numCache>
              </c:numRef>
            </c:plus>
          </c:errBars>
          <c:val>
            <c:numRef>
              <c:f>(Sheet1!$P$5,Sheet1!$AD$5,Sheet1!$AR$5,Sheet1!$BF$5)</c:f>
              <c:numCache>
                <c:formatCode>General</c:formatCode>
                <c:ptCount val="4"/>
                <c:pt idx="0">
                  <c:v>1.0000001557150806</c:v>
                </c:pt>
                <c:pt idx="1">
                  <c:v>1.2528974800035246</c:v>
                </c:pt>
                <c:pt idx="2">
                  <c:v>1.0905160435993844</c:v>
                </c:pt>
                <c:pt idx="3">
                  <c:v>1.05635227086385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8E-4C29-97C2-E633296E66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49829391"/>
        <c:axId val="1"/>
      </c:barChart>
      <c:catAx>
        <c:axId val="15498293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549829391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late 1'!$Q$14</c:f>
              <c:strCache>
                <c:ptCount val="1"/>
                <c:pt idx="0">
                  <c:v>EGFP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late 1'!$V$15:$V$17</c:f>
                <c:numCache>
                  <c:formatCode>General</c:formatCode>
                  <c:ptCount val="3"/>
                  <c:pt idx="0">
                    <c:v>610.5</c:v>
                  </c:pt>
                  <c:pt idx="1">
                    <c:v>538.5</c:v>
                  </c:pt>
                  <c:pt idx="2">
                    <c:v>423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late 1'!$P$15:$P$17</c:f>
              <c:strCache>
                <c:ptCount val="3"/>
                <c:pt idx="0">
                  <c:v>SF</c:v>
                </c:pt>
                <c:pt idx="1">
                  <c:v>CCL2</c:v>
                </c:pt>
                <c:pt idx="2">
                  <c:v>HGF</c:v>
                </c:pt>
              </c:strCache>
            </c:strRef>
          </c:cat>
          <c:val>
            <c:numRef>
              <c:f>'Plate 1'!$Q$15:$Q$17</c:f>
              <c:numCache>
                <c:formatCode>General</c:formatCode>
                <c:ptCount val="3"/>
                <c:pt idx="0">
                  <c:v>6738</c:v>
                </c:pt>
                <c:pt idx="1">
                  <c:v>8748</c:v>
                </c:pt>
                <c:pt idx="2">
                  <c:v>52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E6-48DC-B0C3-14AD0D2C4354}"/>
            </c:ext>
          </c:extLst>
        </c:ser>
        <c:ser>
          <c:idx val="1"/>
          <c:order val="1"/>
          <c:tx>
            <c:strRef>
              <c:f>'Plate 1'!$R$14</c:f>
              <c:strCache>
                <c:ptCount val="1"/>
                <c:pt idx="0">
                  <c:v>MET-KO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late 1'!$W$15:$W$17</c:f>
                <c:numCache>
                  <c:formatCode>General</c:formatCode>
                  <c:ptCount val="3"/>
                  <c:pt idx="0">
                    <c:v>328.2</c:v>
                  </c:pt>
                  <c:pt idx="1">
                    <c:v>308.39999999999998</c:v>
                  </c:pt>
                  <c:pt idx="2">
                    <c:v>273.1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late 1'!$P$15:$P$17</c:f>
              <c:strCache>
                <c:ptCount val="3"/>
                <c:pt idx="0">
                  <c:v>SF</c:v>
                </c:pt>
                <c:pt idx="1">
                  <c:v>CCL2</c:v>
                </c:pt>
                <c:pt idx="2">
                  <c:v>HGF</c:v>
                </c:pt>
              </c:strCache>
            </c:strRef>
          </c:cat>
          <c:val>
            <c:numRef>
              <c:f>'Plate 1'!$R$15:$R$17</c:f>
              <c:numCache>
                <c:formatCode>General</c:formatCode>
                <c:ptCount val="3"/>
                <c:pt idx="0">
                  <c:v>3958</c:v>
                </c:pt>
                <c:pt idx="1">
                  <c:v>3794</c:v>
                </c:pt>
                <c:pt idx="2">
                  <c:v>21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CE6-48DC-B0C3-14AD0D2C43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29057440"/>
        <c:axId val="1926920832"/>
      </c:barChart>
      <c:catAx>
        <c:axId val="1929057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26920832"/>
        <c:crosses val="autoZero"/>
        <c:auto val="1"/>
        <c:lblAlgn val="ctr"/>
        <c:lblOffset val="100"/>
        <c:noMultiLvlLbl val="0"/>
      </c:catAx>
      <c:valAx>
        <c:axId val="1926920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29057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onsumed glucose'!$D$59</c:f>
              <c:strCache>
                <c:ptCount val="1"/>
                <c:pt idx="0">
                  <c:v>SF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consumed glucose'!$G$60:$H$60</c:f>
                <c:numCache>
                  <c:formatCode>General</c:formatCode>
                  <c:ptCount val="2"/>
                  <c:pt idx="0">
                    <c:v>2.2152421830779212</c:v>
                  </c:pt>
                  <c:pt idx="1">
                    <c:v>4.1043108379107363</c:v>
                  </c:pt>
                </c:numCache>
              </c:numRef>
            </c:plus>
          </c:errBars>
          <c:cat>
            <c:strRef>
              <c:f>'consumed glucose'!$C$60:$C$61</c:f>
              <c:strCache>
                <c:ptCount val="2"/>
                <c:pt idx="0">
                  <c:v>pHAGE</c:v>
                </c:pt>
                <c:pt idx="1">
                  <c:v>CCR2+</c:v>
                </c:pt>
              </c:strCache>
            </c:strRef>
          </c:cat>
          <c:val>
            <c:numRef>
              <c:f>'consumed glucose'!$D$60:$D$61</c:f>
              <c:numCache>
                <c:formatCode>General</c:formatCode>
                <c:ptCount val="2"/>
                <c:pt idx="0">
                  <c:v>2.8465259166666645</c:v>
                </c:pt>
                <c:pt idx="1">
                  <c:v>3.65993841666666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18-47A4-89DD-CD7305CB5C4F}"/>
            </c:ext>
          </c:extLst>
        </c:ser>
        <c:ser>
          <c:idx val="1"/>
          <c:order val="1"/>
          <c:tx>
            <c:strRef>
              <c:f>'consumed glucose'!$E$59</c:f>
              <c:strCache>
                <c:ptCount val="1"/>
                <c:pt idx="0">
                  <c:v>CCL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consumed glucose'!$G$61:$H$61</c:f>
                <c:numCache>
                  <c:formatCode>General</c:formatCode>
                  <c:ptCount val="2"/>
                  <c:pt idx="0">
                    <c:v>2.8976264978945325</c:v>
                  </c:pt>
                  <c:pt idx="1">
                    <c:v>1.6585872171740379</c:v>
                  </c:pt>
                </c:numCache>
              </c:numRef>
            </c:plus>
          </c:errBars>
          <c:cat>
            <c:strRef>
              <c:f>'consumed glucose'!$C$60:$C$61</c:f>
              <c:strCache>
                <c:ptCount val="2"/>
                <c:pt idx="0">
                  <c:v>pHAGE</c:v>
                </c:pt>
                <c:pt idx="1">
                  <c:v>CCR2+</c:v>
                </c:pt>
              </c:strCache>
            </c:strRef>
          </c:cat>
          <c:val>
            <c:numRef>
              <c:f>'consumed glucose'!$E$60:$E$61</c:f>
              <c:numCache>
                <c:formatCode>General</c:formatCode>
                <c:ptCount val="2"/>
                <c:pt idx="0">
                  <c:v>4.7501564166666652</c:v>
                </c:pt>
                <c:pt idx="1">
                  <c:v>12.89200224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18-47A4-89DD-CD7305CB5C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797040"/>
        <c:axId val="1"/>
      </c:barChart>
      <c:catAx>
        <c:axId val="227970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2797040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consumed glucose'!$C$52</c:f>
              <c:strCache>
                <c:ptCount val="1"/>
                <c:pt idx="0">
                  <c:v>SF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consumed glucose'!$D$55:$E$55</c:f>
                <c:numCache>
                  <c:formatCode>General</c:formatCode>
                  <c:ptCount val="2"/>
                  <c:pt idx="0">
                    <c:v>0.41075512333755188</c:v>
                  </c:pt>
                  <c:pt idx="1">
                    <c:v>1.4252357955895116</c:v>
                  </c:pt>
                </c:numCache>
              </c:numRef>
            </c:plus>
          </c:errBars>
          <c:cat>
            <c:strRef>
              <c:f>'consumed glucose'!$D$51:$E$51</c:f>
              <c:strCache>
                <c:ptCount val="2"/>
                <c:pt idx="0">
                  <c:v>DCIS.com</c:v>
                </c:pt>
                <c:pt idx="1">
                  <c:v>HCC1937</c:v>
                </c:pt>
              </c:strCache>
            </c:strRef>
          </c:cat>
          <c:val>
            <c:numRef>
              <c:f>'consumed glucose'!$D$52:$E$52</c:f>
              <c:numCache>
                <c:formatCode>General</c:formatCode>
                <c:ptCount val="2"/>
                <c:pt idx="0">
                  <c:v>4.057594529185816</c:v>
                </c:pt>
                <c:pt idx="1">
                  <c:v>6.3963107499999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15-4AA3-801A-55A637E48F96}"/>
            </c:ext>
          </c:extLst>
        </c:ser>
        <c:ser>
          <c:idx val="1"/>
          <c:order val="1"/>
          <c:tx>
            <c:strRef>
              <c:f>'consumed glucose'!$C$53</c:f>
              <c:strCache>
                <c:ptCount val="1"/>
                <c:pt idx="0">
                  <c:v>CCL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'consumed glucose'!$D$56:$E$56</c:f>
                <c:numCache>
                  <c:formatCode>General</c:formatCode>
                  <c:ptCount val="2"/>
                  <c:pt idx="0">
                    <c:v>0.35524767423788267</c:v>
                  </c:pt>
                  <c:pt idx="1">
                    <c:v>2.5827344407448147</c:v>
                  </c:pt>
                </c:numCache>
              </c:numRef>
            </c:plus>
          </c:errBars>
          <c:cat>
            <c:strRef>
              <c:f>'consumed glucose'!$D$51:$E$51</c:f>
              <c:strCache>
                <c:ptCount val="2"/>
                <c:pt idx="0">
                  <c:v>DCIS.com</c:v>
                </c:pt>
                <c:pt idx="1">
                  <c:v>HCC1937</c:v>
                </c:pt>
              </c:strCache>
            </c:strRef>
          </c:cat>
          <c:val>
            <c:numRef>
              <c:f>'consumed glucose'!$D$53:$E$53</c:f>
              <c:numCache>
                <c:formatCode>General</c:formatCode>
                <c:ptCount val="2"/>
                <c:pt idx="0">
                  <c:v>5.2732076644685719</c:v>
                </c:pt>
                <c:pt idx="1">
                  <c:v>12.18584574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15-4AA3-801A-55A637E48F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2795840"/>
        <c:axId val="1"/>
      </c:barChart>
      <c:catAx>
        <c:axId val="227958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aseline="0"/>
            </a:pPr>
            <a:endParaRPr lang="en-US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2795840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Sheet1'!$E$38:$F$38</c:f>
                <c:numCache>
                  <c:formatCode>General</c:formatCode>
                  <c:ptCount val="2"/>
                  <c:pt idx="0">
                    <c:v>11.72</c:v>
                  </c:pt>
                  <c:pt idx="1">
                    <c:v>10.02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Sheet1'!$E$29:$F$29</c:f>
              <c:strCache>
                <c:ptCount val="2"/>
                <c:pt idx="0">
                  <c:v>SF KO</c:v>
                </c:pt>
                <c:pt idx="1">
                  <c:v>CCL2 KO</c:v>
                </c:pt>
              </c:strCache>
            </c:strRef>
          </c:cat>
          <c:val>
            <c:numRef>
              <c:f>'[Chart in Microsoft PowerPoint]Sheet1'!$E$36:$F$36</c:f>
              <c:numCache>
                <c:formatCode>General</c:formatCode>
                <c:ptCount val="2"/>
                <c:pt idx="0">
                  <c:v>45.74</c:v>
                </c:pt>
                <c:pt idx="1">
                  <c:v>34.65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1F-4E87-9D9A-CCF9215283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0584687"/>
        <c:axId val="590585103"/>
      </c:barChart>
      <c:catAx>
        <c:axId val="5905846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0585103"/>
        <c:crosses val="autoZero"/>
        <c:auto val="1"/>
        <c:lblAlgn val="ctr"/>
        <c:lblOffset val="100"/>
        <c:noMultiLvlLbl val="0"/>
      </c:catAx>
      <c:valAx>
        <c:axId val="59058510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905846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264208045422896"/>
          <c:y val="7.7338145231846026E-2"/>
          <c:w val="0.85994295355937656"/>
          <c:h val="0.8200998833479148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5:$F$25</c:f>
                <c:numCache>
                  <c:formatCode>General</c:formatCode>
                  <c:ptCount val="2"/>
                  <c:pt idx="0">
                    <c:v>11.72</c:v>
                  </c:pt>
                  <c:pt idx="1">
                    <c:v>10.02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22:$F$22</c:f>
              <c:strCache>
                <c:ptCount val="2"/>
                <c:pt idx="0">
                  <c:v>SF</c:v>
                </c:pt>
                <c:pt idx="1">
                  <c:v>CCL2</c:v>
                </c:pt>
              </c:strCache>
            </c:strRef>
          </c:cat>
          <c:val>
            <c:numRef>
              <c:f>Sheet1!$E$23:$F$23</c:f>
              <c:numCache>
                <c:formatCode>General</c:formatCode>
                <c:ptCount val="2"/>
                <c:pt idx="0">
                  <c:v>45.74</c:v>
                </c:pt>
                <c:pt idx="1">
                  <c:v>34.65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A9-420C-806C-97B32B33E8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47594368"/>
        <c:axId val="549578672"/>
      </c:barChart>
      <c:catAx>
        <c:axId val="547594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9578672"/>
        <c:crosses val="autoZero"/>
        <c:auto val="1"/>
        <c:lblAlgn val="ctr"/>
        <c:lblOffset val="100"/>
        <c:noMultiLvlLbl val="0"/>
      </c:catAx>
      <c:valAx>
        <c:axId val="549578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47594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CNA_Compilation!$K$19</c:f>
              <c:strCache>
                <c:ptCount val="1"/>
                <c:pt idx="0">
                  <c:v>S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CNA_Compilation!$P$19:$P$21</c:f>
                <c:numCache>
                  <c:formatCode>General</c:formatCode>
                  <c:ptCount val="3"/>
                  <c:pt idx="0">
                    <c:v>4.0660000000000002E-2</c:v>
                  </c:pt>
                  <c:pt idx="1">
                    <c:v>6.6650000000000001E-2</c:v>
                  </c:pt>
                  <c:pt idx="2">
                    <c:v>0.10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CNA_Compilation!$L$18:$M$18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PCNA_Compilation!$L$19:$M$19</c:f>
              <c:numCache>
                <c:formatCode>General</c:formatCode>
                <c:ptCount val="2"/>
                <c:pt idx="0">
                  <c:v>0.97570000000000001</c:v>
                </c:pt>
                <c:pt idx="1">
                  <c:v>0.9075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C4-46AB-A4FE-532C2F3F87B1}"/>
            </c:ext>
          </c:extLst>
        </c:ser>
        <c:ser>
          <c:idx val="1"/>
          <c:order val="1"/>
          <c:tx>
            <c:strRef>
              <c:f>PCNA_Compilation!$K$20</c:f>
              <c:strCache>
                <c:ptCount val="1"/>
                <c:pt idx="0">
                  <c:v>CC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CNA_Compilation!$Q$19:$Q$21</c:f>
                <c:numCache>
                  <c:formatCode>General</c:formatCode>
                  <c:ptCount val="3"/>
                  <c:pt idx="0">
                    <c:v>5.0450000000000002E-2</c:v>
                  </c:pt>
                  <c:pt idx="1">
                    <c:v>5.2880000000000003E-2</c:v>
                  </c:pt>
                  <c:pt idx="2">
                    <c:v>0.1751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CNA_Compilation!$L$18:$M$18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PCNA_Compilation!$L$20:$M$20</c:f>
              <c:numCache>
                <c:formatCode>General</c:formatCode>
                <c:ptCount val="2"/>
                <c:pt idx="0">
                  <c:v>1.3149999999999999</c:v>
                </c:pt>
                <c:pt idx="1">
                  <c:v>0.7364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C4-46AB-A4FE-532C2F3F87B1}"/>
            </c:ext>
          </c:extLst>
        </c:ser>
        <c:ser>
          <c:idx val="2"/>
          <c:order val="2"/>
          <c:tx>
            <c:strRef>
              <c:f>PCNA_Compilation!$K$21</c:f>
              <c:strCache>
                <c:ptCount val="1"/>
                <c:pt idx="0">
                  <c:v>HG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PCNA_Compilation!$P$21:$Q$21</c:f>
                <c:numCache>
                  <c:formatCode>General</c:formatCode>
                  <c:ptCount val="2"/>
                  <c:pt idx="0">
                    <c:v>0.1052</c:v>
                  </c:pt>
                  <c:pt idx="1">
                    <c:v>0.1751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PCNA_Compilation!$L$18:$M$18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PCNA_Compilation!$L$21:$M$21</c:f>
              <c:numCache>
                <c:formatCode>General</c:formatCode>
                <c:ptCount val="2"/>
                <c:pt idx="0">
                  <c:v>1.1819999999999999</c:v>
                </c:pt>
                <c:pt idx="1">
                  <c:v>0.73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7C4-46AB-A4FE-532C2F3F87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283455"/>
        <c:axId val="2123333807"/>
      </c:barChart>
      <c:catAx>
        <c:axId val="742834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3333807"/>
        <c:crosses val="autoZero"/>
        <c:auto val="1"/>
        <c:lblAlgn val="ctr"/>
        <c:lblOffset val="100"/>
        <c:noMultiLvlLbl val="0"/>
      </c:catAx>
      <c:valAx>
        <c:axId val="212333380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42834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Migration _Compilation '!$E$283</c:f>
              <c:strCache>
                <c:ptCount val="1"/>
                <c:pt idx="0">
                  <c:v>S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Migration _Compilation '!$J$283:$J$285</c:f>
                <c:numCache>
                  <c:formatCode>General</c:formatCode>
                  <c:ptCount val="3"/>
                  <c:pt idx="0">
                    <c:v>4.4939999999999998</c:v>
                  </c:pt>
                  <c:pt idx="1">
                    <c:v>1.2070000000000001</c:v>
                  </c:pt>
                  <c:pt idx="2">
                    <c:v>2.427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Migration _Compilation '!$F$282:$G$282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Migration _Compilation '!$F$283:$G$283</c:f>
              <c:numCache>
                <c:formatCode>General</c:formatCode>
                <c:ptCount val="2"/>
                <c:pt idx="0">
                  <c:v>60.89</c:v>
                </c:pt>
                <c:pt idx="1">
                  <c:v>61.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82-4C4C-98F6-BD978F7A5A37}"/>
            </c:ext>
          </c:extLst>
        </c:ser>
        <c:ser>
          <c:idx val="1"/>
          <c:order val="1"/>
          <c:tx>
            <c:strRef>
              <c:f>'[Chart in Microsoft PowerPoint]Migration _Compilation '!$E$284</c:f>
              <c:strCache>
                <c:ptCount val="1"/>
                <c:pt idx="0">
                  <c:v>CC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Migration _Compilation '!$K$283:$K$285</c:f>
                <c:numCache>
                  <c:formatCode>General</c:formatCode>
                  <c:ptCount val="3"/>
                  <c:pt idx="0">
                    <c:v>4.17</c:v>
                  </c:pt>
                  <c:pt idx="1">
                    <c:v>4.8490000000000002</c:v>
                  </c:pt>
                  <c:pt idx="2">
                    <c:v>2.173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Migration _Compilation '!$F$282:$G$282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Migration _Compilation '!$F$284:$G$284</c:f>
              <c:numCache>
                <c:formatCode>General</c:formatCode>
                <c:ptCount val="2"/>
                <c:pt idx="0">
                  <c:v>77.67</c:v>
                </c:pt>
                <c:pt idx="1">
                  <c:v>5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382-4C4C-98F6-BD978F7A5A37}"/>
            </c:ext>
          </c:extLst>
        </c:ser>
        <c:ser>
          <c:idx val="2"/>
          <c:order val="2"/>
          <c:tx>
            <c:strRef>
              <c:f>'[Chart in Microsoft PowerPoint]Migration _Compilation '!$E$285</c:f>
              <c:strCache>
                <c:ptCount val="1"/>
                <c:pt idx="0">
                  <c:v>HG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Migration _Compilation '!$J$285:$K$285</c:f>
                <c:numCache>
                  <c:formatCode>General</c:formatCode>
                  <c:ptCount val="2"/>
                  <c:pt idx="0">
                    <c:v>2.4279999999999999</c:v>
                  </c:pt>
                  <c:pt idx="1">
                    <c:v>2.173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Migration _Compilation '!$F$282:$G$282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Migration _Compilation '!$F$285:$G$285</c:f>
              <c:numCache>
                <c:formatCode>General</c:formatCode>
                <c:ptCount val="2"/>
                <c:pt idx="0">
                  <c:v>74.33</c:v>
                </c:pt>
                <c:pt idx="1">
                  <c:v>59.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382-4C4C-98F6-BD978F7A5A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76197919"/>
        <c:axId val="2123287631"/>
      </c:barChart>
      <c:catAx>
        <c:axId val="1976197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3287631"/>
        <c:crosses val="autoZero"/>
        <c:auto val="1"/>
        <c:lblAlgn val="ctr"/>
        <c:lblOffset val="100"/>
        <c:noMultiLvlLbl val="0"/>
      </c:catAx>
      <c:valAx>
        <c:axId val="2123287631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76197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CC3_Data Compilation '!$Q$20</c:f>
              <c:strCache>
                <c:ptCount val="1"/>
                <c:pt idx="0">
                  <c:v>S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CC3_Data Compilation '!$V$20:$V$22</c:f>
                <c:numCache>
                  <c:formatCode>General</c:formatCode>
                  <c:ptCount val="3"/>
                  <c:pt idx="0">
                    <c:v>7.4319999999999997E-2</c:v>
                  </c:pt>
                  <c:pt idx="1">
                    <c:v>5.0319999999999997E-2</c:v>
                  </c:pt>
                  <c:pt idx="2">
                    <c:v>6.7510000000000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CC3_Data Compilation '!$R$19:$S$19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CC3_Data Compilation '!$R$20:$S$20</c:f>
              <c:numCache>
                <c:formatCode>General</c:formatCode>
                <c:ptCount val="2"/>
                <c:pt idx="0">
                  <c:v>1.214</c:v>
                </c:pt>
                <c:pt idx="1">
                  <c:v>1.576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53-4E98-97B2-A35C8A509BCC}"/>
            </c:ext>
          </c:extLst>
        </c:ser>
        <c:ser>
          <c:idx val="1"/>
          <c:order val="1"/>
          <c:tx>
            <c:strRef>
              <c:f>'[Chart in Microsoft PowerPoint]CC3_Data Compilation '!$Q$21</c:f>
              <c:strCache>
                <c:ptCount val="1"/>
                <c:pt idx="0">
                  <c:v>CC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CC3_Data Compilation '!$W$20:$W$22</c:f>
                <c:numCache>
                  <c:formatCode>General</c:formatCode>
                  <c:ptCount val="3"/>
                  <c:pt idx="0">
                    <c:v>0.13980000000000001</c:v>
                  </c:pt>
                  <c:pt idx="1">
                    <c:v>8.0399999999999999E-2</c:v>
                  </c:pt>
                  <c:pt idx="2">
                    <c:v>0.1275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CC3_Data Compilation '!$R$19:$S$19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CC3_Data Compilation '!$R$21:$S$21</c:f>
              <c:numCache>
                <c:formatCode>General</c:formatCode>
                <c:ptCount val="2"/>
                <c:pt idx="0">
                  <c:v>0.90600000000000003</c:v>
                </c:pt>
                <c:pt idx="1">
                  <c:v>1.3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553-4E98-97B2-A35C8A509BCC}"/>
            </c:ext>
          </c:extLst>
        </c:ser>
        <c:ser>
          <c:idx val="2"/>
          <c:order val="2"/>
          <c:tx>
            <c:strRef>
              <c:f>'[Chart in Microsoft PowerPoint]CC3_Data Compilation '!$Q$22</c:f>
              <c:strCache>
                <c:ptCount val="1"/>
                <c:pt idx="0">
                  <c:v>HG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CC3_Data Compilation '!$W$20:$W$22</c:f>
                <c:numCache>
                  <c:formatCode>General</c:formatCode>
                  <c:ptCount val="3"/>
                  <c:pt idx="0">
                    <c:v>0.13980000000000001</c:v>
                  </c:pt>
                  <c:pt idx="1">
                    <c:v>8.0399999999999999E-2</c:v>
                  </c:pt>
                  <c:pt idx="2">
                    <c:v>0.1275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CC3_Data Compilation '!$R$19:$S$19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CC3_Data Compilation '!$R$22:$S$22</c:f>
              <c:numCache>
                <c:formatCode>General</c:formatCode>
                <c:ptCount val="2"/>
                <c:pt idx="0">
                  <c:v>0.79369999999999996</c:v>
                </c:pt>
                <c:pt idx="1">
                  <c:v>1.4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553-4E98-97B2-A35C8A509B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21866703"/>
        <c:axId val="2123335055"/>
      </c:barChart>
      <c:catAx>
        <c:axId val="2121866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3335055"/>
        <c:crosses val="autoZero"/>
        <c:auto val="1"/>
        <c:lblAlgn val="ctr"/>
        <c:lblOffset val="100"/>
        <c:noMultiLvlLbl val="0"/>
      </c:catAx>
      <c:valAx>
        <c:axId val="212333505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21866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Data Compilation Migration '!$R$62</c:f>
              <c:strCache>
                <c:ptCount val="1"/>
                <c:pt idx="0">
                  <c:v>S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Data Compilation Migration '!$W$62:$W$64</c:f>
                <c:numCache>
                  <c:formatCode>General</c:formatCode>
                  <c:ptCount val="3"/>
                  <c:pt idx="0">
                    <c:v>1.798</c:v>
                  </c:pt>
                  <c:pt idx="1">
                    <c:v>1.589</c:v>
                  </c:pt>
                  <c:pt idx="2">
                    <c:v>1.2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Data Compilation Migration '!$S$61:$T$61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Data Compilation Migration '!$S$62:$T$62</c:f>
              <c:numCache>
                <c:formatCode>General</c:formatCode>
                <c:ptCount val="2"/>
                <c:pt idx="0">
                  <c:v>28.15</c:v>
                </c:pt>
                <c:pt idx="1">
                  <c:v>32.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3BD-4FF5-8E7D-068C911412A1}"/>
            </c:ext>
          </c:extLst>
        </c:ser>
        <c:ser>
          <c:idx val="1"/>
          <c:order val="1"/>
          <c:tx>
            <c:strRef>
              <c:f>'[Chart in Microsoft PowerPoint]Data Compilation Migration '!$R$63</c:f>
              <c:strCache>
                <c:ptCount val="1"/>
                <c:pt idx="0">
                  <c:v>CC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Data Compilation Migration '!$X$62:$X$64</c:f>
                <c:numCache>
                  <c:formatCode>General</c:formatCode>
                  <c:ptCount val="3"/>
                  <c:pt idx="0">
                    <c:v>2.0289999999999999</c:v>
                  </c:pt>
                  <c:pt idx="1">
                    <c:v>1.8580000000000001</c:v>
                  </c:pt>
                  <c:pt idx="2">
                    <c:v>2.077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Data Compilation Migration '!$S$61:$T$61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Data Compilation Migration '!$S$63:$T$63</c:f>
              <c:numCache>
                <c:formatCode>General</c:formatCode>
                <c:ptCount val="2"/>
                <c:pt idx="0">
                  <c:v>44.59</c:v>
                </c:pt>
                <c:pt idx="1">
                  <c:v>31.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3BD-4FF5-8E7D-068C911412A1}"/>
            </c:ext>
          </c:extLst>
        </c:ser>
        <c:ser>
          <c:idx val="2"/>
          <c:order val="2"/>
          <c:tx>
            <c:strRef>
              <c:f>'[Chart in Microsoft PowerPoint]Data Compilation Migration '!$R$64</c:f>
              <c:strCache>
                <c:ptCount val="1"/>
                <c:pt idx="0">
                  <c:v>HG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Data Compilation Migration '!$X$62:$X$64</c:f>
                <c:numCache>
                  <c:formatCode>General</c:formatCode>
                  <c:ptCount val="3"/>
                  <c:pt idx="0">
                    <c:v>2.0289999999999999</c:v>
                  </c:pt>
                  <c:pt idx="1">
                    <c:v>1.8580000000000001</c:v>
                  </c:pt>
                  <c:pt idx="2">
                    <c:v>2.077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Data Compilation Migration '!$S$61:$T$61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Data Compilation Migration '!$S$64:$T$64</c:f>
              <c:numCache>
                <c:formatCode>General</c:formatCode>
                <c:ptCount val="2"/>
                <c:pt idx="0">
                  <c:v>51.43</c:v>
                </c:pt>
                <c:pt idx="1">
                  <c:v>28.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3BD-4FF5-8E7D-068C911412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9871839"/>
        <c:axId val="1434078127"/>
      </c:barChart>
      <c:catAx>
        <c:axId val="13398718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4078127"/>
        <c:crosses val="autoZero"/>
        <c:auto val="1"/>
        <c:lblAlgn val="ctr"/>
        <c:lblOffset val="100"/>
        <c:noMultiLvlLbl val="0"/>
      </c:catAx>
      <c:valAx>
        <c:axId val="1434078127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98718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solidFill>
            <a:schemeClr val="bg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pcna'!$D$18</c:f>
              <c:strCache>
                <c:ptCount val="1"/>
                <c:pt idx="0">
                  <c:v>S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pcna'!$I$18:$I$20</c:f>
                <c:numCache>
                  <c:formatCode>General</c:formatCode>
                  <c:ptCount val="3"/>
                  <c:pt idx="0">
                    <c:v>0.1555</c:v>
                  </c:pt>
                  <c:pt idx="1">
                    <c:v>0.21329999999999999</c:v>
                  </c:pt>
                  <c:pt idx="2">
                    <c:v>0.368700000000000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pcna'!$E$17:$F$17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pcna'!$E$18:$F$18</c:f>
              <c:numCache>
                <c:formatCode>General</c:formatCode>
                <c:ptCount val="2"/>
                <c:pt idx="0">
                  <c:v>1.708</c:v>
                </c:pt>
                <c:pt idx="1">
                  <c:v>1.249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B1A-4990-AB44-3F18A064F97B}"/>
            </c:ext>
          </c:extLst>
        </c:ser>
        <c:ser>
          <c:idx val="1"/>
          <c:order val="1"/>
          <c:tx>
            <c:strRef>
              <c:f>'[Chart in Microsoft PowerPoint]pcna'!$D$19</c:f>
              <c:strCache>
                <c:ptCount val="1"/>
                <c:pt idx="0">
                  <c:v>CC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pcna'!$J$18:$J$20</c:f>
                <c:numCache>
                  <c:formatCode>General</c:formatCode>
                  <c:ptCount val="3"/>
                  <c:pt idx="0">
                    <c:v>9.4350000000000003E-2</c:v>
                  </c:pt>
                  <c:pt idx="1">
                    <c:v>0.29770000000000002</c:v>
                  </c:pt>
                  <c:pt idx="2">
                    <c:v>0.2212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pcna'!$E$17:$F$17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pcna'!$E$19:$F$19</c:f>
              <c:numCache>
                <c:formatCode>General</c:formatCode>
                <c:ptCount val="2"/>
                <c:pt idx="0">
                  <c:v>3.1030000000000002</c:v>
                </c:pt>
                <c:pt idx="1">
                  <c:v>2.684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B1A-4990-AB44-3F18A064F97B}"/>
            </c:ext>
          </c:extLst>
        </c:ser>
        <c:ser>
          <c:idx val="2"/>
          <c:order val="2"/>
          <c:tx>
            <c:strRef>
              <c:f>'[Chart in Microsoft PowerPoint]pcna'!$D$20</c:f>
              <c:strCache>
                <c:ptCount val="1"/>
                <c:pt idx="0">
                  <c:v>HG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pcna'!$I$20:$J$20</c:f>
                <c:numCache>
                  <c:formatCode>General</c:formatCode>
                  <c:ptCount val="2"/>
                  <c:pt idx="0">
                    <c:v>0.36870000000000003</c:v>
                  </c:pt>
                  <c:pt idx="1">
                    <c:v>0.2212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pcna'!$E$17:$F$17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pcna'!$E$20:$F$20</c:f>
              <c:numCache>
                <c:formatCode>General</c:formatCode>
                <c:ptCount val="2"/>
                <c:pt idx="0">
                  <c:v>3.4159999999999999</c:v>
                </c:pt>
                <c:pt idx="1">
                  <c:v>2.011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B1A-4990-AB44-3F18A064F9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34855055"/>
        <c:axId val="1435224655"/>
      </c:barChart>
      <c:catAx>
        <c:axId val="13348550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5224655"/>
        <c:crosses val="autoZero"/>
        <c:auto val="1"/>
        <c:lblAlgn val="ctr"/>
        <c:lblOffset val="100"/>
        <c:noMultiLvlLbl val="0"/>
      </c:catAx>
      <c:valAx>
        <c:axId val="143522465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3485505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556074675614691"/>
          <c:y val="5.0925888017293613E-2"/>
          <c:w val="0.85211787464497113"/>
          <c:h val="0.6818502200489395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cc3'!$C$15</c:f>
              <c:strCache>
                <c:ptCount val="1"/>
                <c:pt idx="0">
                  <c:v>S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cc3'!$H$15:$H$17</c:f>
                <c:numCache>
                  <c:formatCode>General</c:formatCode>
                  <c:ptCount val="3"/>
                  <c:pt idx="0">
                    <c:v>8.2890000000000005E-2</c:v>
                  </c:pt>
                  <c:pt idx="1">
                    <c:v>4.0370000000000003E-2</c:v>
                  </c:pt>
                  <c:pt idx="2">
                    <c:v>4.46900000000000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cc3'!$D$14:$E$14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cc3'!$D$15:$E$15</c:f>
              <c:numCache>
                <c:formatCode>General</c:formatCode>
                <c:ptCount val="2"/>
                <c:pt idx="0">
                  <c:v>1.1990000000000001</c:v>
                </c:pt>
                <c:pt idx="1">
                  <c:v>1.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7B-43DC-B4E4-89649BBAD9C6}"/>
            </c:ext>
          </c:extLst>
        </c:ser>
        <c:ser>
          <c:idx val="1"/>
          <c:order val="1"/>
          <c:tx>
            <c:strRef>
              <c:f>'[Chart in Microsoft PowerPoint]cc3'!$C$16</c:f>
              <c:strCache>
                <c:ptCount val="1"/>
                <c:pt idx="0">
                  <c:v>CCL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cc3'!$I$15:$I$17</c:f>
                <c:numCache>
                  <c:formatCode>General</c:formatCode>
                  <c:ptCount val="3"/>
                  <c:pt idx="0">
                    <c:v>0.1082</c:v>
                  </c:pt>
                  <c:pt idx="1">
                    <c:v>5.0869999999999999E-2</c:v>
                  </c:pt>
                  <c:pt idx="2">
                    <c:v>8.556999999999999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cc3'!$D$14:$E$14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cc3'!$D$16:$E$16</c:f>
              <c:numCache>
                <c:formatCode>General</c:formatCode>
                <c:ptCount val="2"/>
                <c:pt idx="0">
                  <c:v>0.67830000000000001</c:v>
                </c:pt>
                <c:pt idx="1">
                  <c:v>1.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67B-43DC-B4E4-89649BBAD9C6}"/>
            </c:ext>
          </c:extLst>
        </c:ser>
        <c:ser>
          <c:idx val="2"/>
          <c:order val="2"/>
          <c:tx>
            <c:strRef>
              <c:f>'[Chart in Microsoft PowerPoint]cc3'!$C$17</c:f>
              <c:strCache>
                <c:ptCount val="1"/>
                <c:pt idx="0">
                  <c:v>HG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cc3'!$H$17:$I$17</c:f>
                <c:numCache>
                  <c:formatCode>General</c:formatCode>
                  <c:ptCount val="2"/>
                  <c:pt idx="0">
                    <c:v>4.4690000000000001E-2</c:v>
                  </c:pt>
                  <c:pt idx="1">
                    <c:v>8.556999999999999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cc3'!$D$14:$E$14</c:f>
              <c:strCache>
                <c:ptCount val="2"/>
                <c:pt idx="0">
                  <c:v>EGFP</c:v>
                </c:pt>
                <c:pt idx="1">
                  <c:v>MET-KO</c:v>
                </c:pt>
              </c:strCache>
            </c:strRef>
          </c:cat>
          <c:val>
            <c:numRef>
              <c:f>'[Chart in Microsoft PowerPoint]cc3'!$D$17:$E$17</c:f>
              <c:numCache>
                <c:formatCode>General</c:formatCode>
                <c:ptCount val="2"/>
                <c:pt idx="0">
                  <c:v>0.65780000000000005</c:v>
                </c:pt>
                <c:pt idx="1">
                  <c:v>1.0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67B-43DC-B4E4-89649BBAD9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21621919"/>
        <c:axId val="1434091439"/>
      </c:barChart>
      <c:catAx>
        <c:axId val="15216219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434091439"/>
        <c:crosses val="autoZero"/>
        <c:auto val="1"/>
        <c:lblAlgn val="ctr"/>
        <c:lblOffset val="100"/>
        <c:noMultiLvlLbl val="0"/>
      </c:catAx>
      <c:valAx>
        <c:axId val="143409143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52162191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0144123781006423"/>
          <c:y val="0.86821806986227335"/>
          <c:w val="0.6365754387600151"/>
          <c:h val="0.1252824951279825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B473DF-D4D0-440C-BBA0-8374CF4E7208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15791"/>
            <a:ext cx="5486400" cy="418338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967"/>
            <a:ext cx="2971800" cy="46482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5D9A10-C76F-425B-8D88-03799133FB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65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787426"/>
            <a:ext cx="7772400" cy="261337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6908800"/>
            <a:ext cx="6400800" cy="31157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165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506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488249"/>
            <a:ext cx="2057400" cy="1040271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488249"/>
            <a:ext cx="6019800" cy="1040271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022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979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7834489"/>
            <a:ext cx="7772400" cy="2421467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5167493"/>
            <a:ext cx="7772400" cy="266699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0495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844803"/>
            <a:ext cx="4038600" cy="804615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844803"/>
            <a:ext cx="4038600" cy="8046156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541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2729089"/>
            <a:ext cx="4040188" cy="113735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3866444"/>
            <a:ext cx="4040188" cy="7024512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2729089"/>
            <a:ext cx="4041775" cy="113735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3866444"/>
            <a:ext cx="4041775" cy="7024512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93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458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180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485423"/>
            <a:ext cx="3008313" cy="206586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485425"/>
            <a:ext cx="5111751" cy="1040553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2551291"/>
            <a:ext cx="3008313" cy="833966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269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8534402"/>
            <a:ext cx="5486400" cy="1007535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1089377"/>
            <a:ext cx="5486400" cy="73152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9541937"/>
            <a:ext cx="5486400" cy="1430865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965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488245"/>
            <a:ext cx="8229600" cy="2032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844803"/>
            <a:ext cx="8229600" cy="8046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1300181"/>
            <a:ext cx="2133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C791A0-DBE2-442C-A865-73B42367140D}" type="datetimeFigureOut">
              <a:rPr lang="en-US" smtClean="0"/>
              <a:t>1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1300181"/>
            <a:ext cx="2895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1300181"/>
            <a:ext cx="2133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34C3D4-AE35-44BE-BE66-77BB3ECE7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376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0.xml"/><Relationship Id="rId3" Type="http://schemas.openxmlformats.org/officeDocument/2006/relationships/chart" Target="../charts/chart5.xml"/><Relationship Id="rId7" Type="http://schemas.openxmlformats.org/officeDocument/2006/relationships/chart" Target="../charts/chart9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2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3" Type="http://schemas.openxmlformats.org/officeDocument/2006/relationships/image" Target="../media/image2.jpeg"/><Relationship Id="rId7" Type="http://schemas.openxmlformats.org/officeDocument/2006/relationships/image" Target="../media/image4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3.jpeg"/><Relationship Id="rId9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2782948-1CAA-421C-9993-0D8354583DA0}"/>
              </a:ext>
            </a:extLst>
          </p:cNvPr>
          <p:cNvGrpSpPr/>
          <p:nvPr/>
        </p:nvGrpSpPr>
        <p:grpSpPr>
          <a:xfrm>
            <a:off x="2386758" y="2989509"/>
            <a:ext cx="3844055" cy="2807528"/>
            <a:chOff x="-4069945" y="1396330"/>
            <a:chExt cx="3844055" cy="2807528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4D17E413-3E5B-4001-A521-60540FBF2FC7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-3599602" y="1598763"/>
            <a:ext cx="3373712" cy="24026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93E6982-F826-41C6-941D-5B55D52E97E4}"/>
                </a:ext>
              </a:extLst>
            </p:cNvPr>
            <p:cNvSpPr txBox="1"/>
            <p:nvPr/>
          </p:nvSpPr>
          <p:spPr>
            <a:xfrm rot="16200000">
              <a:off x="-5242876" y="2569261"/>
              <a:ext cx="280752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Fluorescence intensity phospho-MET Y1234/1235 normalized to MET 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C5468344-99A8-437C-AD2B-1D470663A3D8}"/>
              </a:ext>
            </a:extLst>
          </p:cNvPr>
          <p:cNvSpPr txBox="1"/>
          <p:nvPr/>
        </p:nvSpPr>
        <p:spPr>
          <a:xfrm>
            <a:off x="2386758" y="6394964"/>
            <a:ext cx="428673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Effects of CCL2 and CCR2-KO on phospho-MET expression in MCF10CA1d cells as determined by RPP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CF10CA1d control cells or CRISPR knockout of CCR2 were treated with / without CCL2 for 4 hours and analyzed by RPPA. Fluorescence intensity of Phospho-MET (Y1234/5) expression normalized to MET is shown. Data on phospho-MET (Y1349) expression was not available from the RPPA. Samples were assayed in quadruplicate. Mean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D are shown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amples were plated in triplicate and experiments were performed three times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CA40D59-8EAB-4C4B-899D-7A5630A40629}"/>
              </a:ext>
            </a:extLst>
          </p:cNvPr>
          <p:cNvSpPr txBox="1"/>
          <p:nvPr/>
        </p:nvSpPr>
        <p:spPr>
          <a:xfrm>
            <a:off x="3137502" y="5437822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D335526-3434-4E43-A667-32A9E53E4440}"/>
              </a:ext>
            </a:extLst>
          </p:cNvPr>
          <p:cNvSpPr txBox="1"/>
          <p:nvPr/>
        </p:nvSpPr>
        <p:spPr>
          <a:xfrm>
            <a:off x="4006718" y="543782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CL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C459A3-5A27-4770-934C-2328918D515F}"/>
              </a:ext>
            </a:extLst>
          </p:cNvPr>
          <p:cNvSpPr txBox="1"/>
          <p:nvPr/>
        </p:nvSpPr>
        <p:spPr>
          <a:xfrm>
            <a:off x="4640871" y="5437822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6B841D-90DD-43B7-B57E-C025467DEAE7}"/>
              </a:ext>
            </a:extLst>
          </p:cNvPr>
          <p:cNvSpPr txBox="1"/>
          <p:nvPr/>
        </p:nvSpPr>
        <p:spPr>
          <a:xfrm>
            <a:off x="5517294" y="543782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CL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CA173E-7D8F-4899-AAA2-AA941A5DDBB0}"/>
              </a:ext>
            </a:extLst>
          </p:cNvPr>
          <p:cNvSpPr txBox="1"/>
          <p:nvPr/>
        </p:nvSpPr>
        <p:spPr>
          <a:xfrm>
            <a:off x="3416876" y="5784337"/>
            <a:ext cx="6783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CD8A56-2174-4610-9DC1-028FF689E746}"/>
              </a:ext>
            </a:extLst>
          </p:cNvPr>
          <p:cNvSpPr txBox="1"/>
          <p:nvPr/>
        </p:nvSpPr>
        <p:spPr>
          <a:xfrm>
            <a:off x="4875769" y="5783391"/>
            <a:ext cx="8755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CR2-KO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920B436-69F7-484B-915B-5321D2F879F4}"/>
              </a:ext>
            </a:extLst>
          </p:cNvPr>
          <p:cNvCxnSpPr>
            <a:cxnSpLocks/>
          </p:cNvCxnSpPr>
          <p:nvPr/>
        </p:nvCxnSpPr>
        <p:spPr>
          <a:xfrm>
            <a:off x="3276600" y="5714821"/>
            <a:ext cx="12673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BC7B1E4-8409-4BB2-BEB3-C8688E1FE014}"/>
              </a:ext>
            </a:extLst>
          </p:cNvPr>
          <p:cNvCxnSpPr>
            <a:cxnSpLocks/>
          </p:cNvCxnSpPr>
          <p:nvPr/>
        </p:nvCxnSpPr>
        <p:spPr>
          <a:xfrm>
            <a:off x="4729894" y="5714821"/>
            <a:ext cx="126735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104363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047DF031-A880-466A-9436-DB4804C020C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7941551"/>
              </p:ext>
            </p:extLst>
          </p:nvPr>
        </p:nvGraphicFramePr>
        <p:xfrm>
          <a:off x="2582699" y="5535570"/>
          <a:ext cx="3604554" cy="22523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323ECDC-CA70-47FD-A024-043235EB2A7B}"/>
              </a:ext>
            </a:extLst>
          </p:cNvPr>
          <p:cNvSpPr txBox="1"/>
          <p:nvPr/>
        </p:nvSpPr>
        <p:spPr>
          <a:xfrm>
            <a:off x="1981200" y="8054960"/>
            <a:ext cx="4953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CCL2 stimulation and CCR2-KO have no effect on HGF protein levels in DCIS.com cell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HGF expression was analyzed by ELISA f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CIS.com cells treated with or without 100 ng/ml CCL2 for 24 hours 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CIS.com cells with wildtype CCR2 expression (WT) or with CCR2 knockout (CCR2-KO). Statistical analysis was performed using two tailed T-test. Significance was determined by p&lt;0.05. ns.=not significant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en-U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amples were plated in triplicate and experiments were performed three times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12FA3B9-E813-442E-8F29-A9401EF7EB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0533361"/>
              </p:ext>
            </p:extLst>
          </p:nvPr>
        </p:nvGraphicFramePr>
        <p:xfrm>
          <a:off x="2590800" y="2240068"/>
          <a:ext cx="37338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6DA460C-1506-47DB-87A3-582D690545E1}"/>
              </a:ext>
            </a:extLst>
          </p:cNvPr>
          <p:cNvSpPr txBox="1"/>
          <p:nvPr/>
        </p:nvSpPr>
        <p:spPr>
          <a:xfrm rot="16200000">
            <a:off x="1936775" y="3325662"/>
            <a:ext cx="10310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GF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34DCA2-69A4-4985-8B3F-971C363F475E}"/>
              </a:ext>
            </a:extLst>
          </p:cNvPr>
          <p:cNvSpPr txBox="1"/>
          <p:nvPr/>
        </p:nvSpPr>
        <p:spPr>
          <a:xfrm rot="16200000">
            <a:off x="1890574" y="6315509"/>
            <a:ext cx="10310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GF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3A47AC7-3A4A-4314-8E2F-4764048CF6AF}"/>
              </a:ext>
            </a:extLst>
          </p:cNvPr>
          <p:cNvSpPr txBox="1"/>
          <p:nvPr/>
        </p:nvSpPr>
        <p:spPr>
          <a:xfrm>
            <a:off x="1899905" y="2075264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87CE875-8F67-4185-A46A-0FC9CDC537D6}"/>
              </a:ext>
            </a:extLst>
          </p:cNvPr>
          <p:cNvSpPr txBox="1"/>
          <p:nvPr/>
        </p:nvSpPr>
        <p:spPr>
          <a:xfrm>
            <a:off x="1920650" y="5065112"/>
            <a:ext cx="4138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20C38FD-712E-4E9D-93E1-A768D09E6F8D}"/>
              </a:ext>
            </a:extLst>
          </p:cNvPr>
          <p:cNvSpPr txBox="1"/>
          <p:nvPr/>
        </p:nvSpPr>
        <p:spPr>
          <a:xfrm>
            <a:off x="5181600" y="274320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0377F18-9546-4188-A4E9-5C2A992A565C}"/>
              </a:ext>
            </a:extLst>
          </p:cNvPr>
          <p:cNvSpPr txBox="1"/>
          <p:nvPr/>
        </p:nvSpPr>
        <p:spPr>
          <a:xfrm>
            <a:off x="5052675" y="6068693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50779E-EFEC-4DE6-914E-1E70C4A1330B}"/>
              </a:ext>
            </a:extLst>
          </p:cNvPr>
          <p:cNvSpPr txBox="1"/>
          <p:nvPr/>
        </p:nvSpPr>
        <p:spPr>
          <a:xfrm>
            <a:off x="3539281" y="7644454"/>
            <a:ext cx="21952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CCR2-KO</a:t>
            </a:r>
          </a:p>
        </p:txBody>
      </p:sp>
    </p:spTree>
    <p:extLst>
      <p:ext uri="{BB962C8B-B14F-4D97-AF65-F5344CB8AC3E}">
        <p14:creationId xmlns:p14="http://schemas.microsoft.com/office/powerpoint/2010/main" val="10018442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FBA4CE3-1BB4-42A1-9647-78CB4F1F28E5}"/>
              </a:ext>
            </a:extLst>
          </p:cNvPr>
          <p:cNvSpPr/>
          <p:nvPr/>
        </p:nvSpPr>
        <p:spPr>
          <a:xfrm>
            <a:off x="628650" y="9958790"/>
            <a:ext cx="7886700" cy="24570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3. Gene ablation of MET inhibits CCL2/CCR2-mediated migration, proliferation and survival of breast cancer cell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CIS.com or HCC1937 breast cancer cells with MET knockout (MET-KO) or EGFP control cells were treated with 100 ng/ml CCL2 or 100ng/ml of HGF as a positive control for 24 hours and assessed for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ound closure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B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proliferation by PCNA immunostaining, and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cell death by cleaved caspase-3 immunostaining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ol or MET-KO DCIS.com cells were treated with/without CCL2 or HGF and cultured in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trigel:collage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or 10 days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D cultures were measured for changes in spheroid growth. Protein expression and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heroid size were measured using image J. Statistical analysis was performed using ONE-WAY ANOVA with Bonferroni post-hoc comparison. 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significance was determined by *p&lt;0.05. **p&lt;0.01, ***p&lt; 0.0001. Mean ± SEM are shown.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amples were plated in triplicate and experiments were performed three times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E53349AB-26F2-4D61-8507-C0DFFFB92B4B}"/>
              </a:ext>
            </a:extLst>
          </p:cNvPr>
          <p:cNvGrpSpPr/>
          <p:nvPr/>
        </p:nvGrpSpPr>
        <p:grpSpPr>
          <a:xfrm>
            <a:off x="1515555" y="301228"/>
            <a:ext cx="6112889" cy="9495877"/>
            <a:chOff x="804520" y="228600"/>
            <a:chExt cx="6112889" cy="9495877"/>
          </a:xfrm>
        </p:grpSpPr>
        <p:graphicFrame>
          <p:nvGraphicFramePr>
            <p:cNvPr id="72" name="Chart 71">
              <a:extLst>
                <a:ext uri="{FF2B5EF4-FFF2-40B4-BE49-F238E27FC236}">
                  <a16:creationId xmlns:a16="http://schemas.microsoft.com/office/drawing/2014/main" id="{3A47D5AF-89AD-4CE0-A2A4-FF45674E907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17850665"/>
                </p:ext>
              </p:extLst>
            </p:nvPr>
          </p:nvGraphicFramePr>
          <p:xfrm>
            <a:off x="3946862" y="3114048"/>
            <a:ext cx="2649681" cy="171656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3" name="Chart 32">
              <a:extLst>
                <a:ext uri="{FF2B5EF4-FFF2-40B4-BE49-F238E27FC236}">
                  <a16:creationId xmlns:a16="http://schemas.microsoft.com/office/drawing/2014/main" id="{2BB1B8F8-B14C-4C8F-A3A3-26666502E0D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11354776"/>
                </p:ext>
              </p:extLst>
            </p:nvPr>
          </p:nvGraphicFramePr>
          <p:xfrm>
            <a:off x="3948783" y="609557"/>
            <a:ext cx="2942158" cy="15612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1337EC2-8E22-4D87-85EE-9A717BFE65B0}"/>
                </a:ext>
              </a:extLst>
            </p:cNvPr>
            <p:cNvSpPr/>
            <p:nvPr/>
          </p:nvSpPr>
          <p:spPr>
            <a:xfrm>
              <a:off x="4294987" y="369136"/>
              <a:ext cx="856325" cy="24375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CC1937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253560CC-E906-46AA-BFD7-3C3204C3EA27}"/>
                </a:ext>
              </a:extLst>
            </p:cNvPr>
            <p:cNvGrpSpPr/>
            <p:nvPr/>
          </p:nvGrpSpPr>
          <p:grpSpPr>
            <a:xfrm>
              <a:off x="5014676" y="653196"/>
              <a:ext cx="1164310" cy="243757"/>
              <a:chOff x="6410965" y="939600"/>
              <a:chExt cx="406430" cy="189210"/>
            </a:xfrm>
          </p:grpSpPr>
          <p:sp>
            <p:nvSpPr>
              <p:cNvPr id="45" name="Right Bracket 44">
                <a:extLst>
                  <a:ext uri="{FF2B5EF4-FFF2-40B4-BE49-F238E27FC236}">
                    <a16:creationId xmlns:a16="http://schemas.microsoft.com/office/drawing/2014/main" id="{82B4900B-4454-451F-8C73-13A6FB5FDDFD}"/>
                  </a:ext>
                </a:extLst>
              </p:cNvPr>
              <p:cNvSpPr/>
              <p:nvPr/>
            </p:nvSpPr>
            <p:spPr>
              <a:xfrm rot="16200000">
                <a:off x="6587627" y="872708"/>
                <a:ext cx="53105" cy="406430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6C44C41-9FAB-4B1F-8B27-707AE97DCD8E}"/>
                  </a:ext>
                </a:extLst>
              </p:cNvPr>
              <p:cNvSpPr txBox="1"/>
              <p:nvPr/>
            </p:nvSpPr>
            <p:spPr>
              <a:xfrm>
                <a:off x="6559652" y="939600"/>
                <a:ext cx="98866" cy="1892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0C9ECB70-9B2E-4FCC-8E17-75A671521FAD}"/>
                </a:ext>
              </a:extLst>
            </p:cNvPr>
            <p:cNvGrpSpPr/>
            <p:nvPr/>
          </p:nvGrpSpPr>
          <p:grpSpPr>
            <a:xfrm>
              <a:off x="5258658" y="764259"/>
              <a:ext cx="1164310" cy="243757"/>
              <a:chOff x="6410965" y="939600"/>
              <a:chExt cx="406430" cy="189210"/>
            </a:xfrm>
          </p:grpSpPr>
          <p:sp>
            <p:nvSpPr>
              <p:cNvPr id="48" name="Right Bracket 47">
                <a:extLst>
                  <a:ext uri="{FF2B5EF4-FFF2-40B4-BE49-F238E27FC236}">
                    <a16:creationId xmlns:a16="http://schemas.microsoft.com/office/drawing/2014/main" id="{DE8C7A91-90EE-4198-80CA-2B6D698B035C}"/>
                  </a:ext>
                </a:extLst>
              </p:cNvPr>
              <p:cNvSpPr/>
              <p:nvPr/>
            </p:nvSpPr>
            <p:spPr>
              <a:xfrm rot="16200000">
                <a:off x="6587627" y="872708"/>
                <a:ext cx="53105" cy="406430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EF5947F1-D5A7-4132-B11A-298B23621591}"/>
                  </a:ext>
                </a:extLst>
              </p:cNvPr>
              <p:cNvSpPr txBox="1"/>
              <p:nvPr/>
            </p:nvSpPr>
            <p:spPr>
              <a:xfrm>
                <a:off x="6559652" y="939600"/>
                <a:ext cx="98866" cy="1892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109922B-1AEB-497E-819E-38800D56E6F6}"/>
                </a:ext>
              </a:extLst>
            </p:cNvPr>
            <p:cNvSpPr txBox="1"/>
            <p:nvPr/>
          </p:nvSpPr>
          <p:spPr>
            <a:xfrm>
              <a:off x="4257533" y="2842093"/>
              <a:ext cx="856325" cy="2112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CC1937</a:t>
              </a:r>
            </a:p>
          </p:txBody>
        </p: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D8AC557B-FE4D-460A-BF14-8A4B4436D3DA}"/>
                </a:ext>
              </a:extLst>
            </p:cNvPr>
            <p:cNvGrpSpPr/>
            <p:nvPr/>
          </p:nvGrpSpPr>
          <p:grpSpPr>
            <a:xfrm>
              <a:off x="4949934" y="3014725"/>
              <a:ext cx="896163" cy="218200"/>
              <a:chOff x="6410965" y="907069"/>
              <a:chExt cx="406430" cy="195406"/>
            </a:xfrm>
          </p:grpSpPr>
          <p:sp>
            <p:nvSpPr>
              <p:cNvPr id="53" name="Right Bracket 52">
                <a:extLst>
                  <a:ext uri="{FF2B5EF4-FFF2-40B4-BE49-F238E27FC236}">
                    <a16:creationId xmlns:a16="http://schemas.microsoft.com/office/drawing/2014/main" id="{3553C027-B498-4B1F-8FF5-9B1B2013A992}"/>
                  </a:ext>
                </a:extLst>
              </p:cNvPr>
              <p:cNvSpPr/>
              <p:nvPr/>
            </p:nvSpPr>
            <p:spPr>
              <a:xfrm rot="16200000">
                <a:off x="6587627" y="872708"/>
                <a:ext cx="53105" cy="406430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9C7C7112-7160-41EF-822B-B6CA3C48573A}"/>
                  </a:ext>
                </a:extLst>
              </p:cNvPr>
              <p:cNvSpPr txBox="1"/>
              <p:nvPr/>
            </p:nvSpPr>
            <p:spPr>
              <a:xfrm>
                <a:off x="6554918" y="907069"/>
                <a:ext cx="209375" cy="1892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DB8DCB0B-22FD-46A4-99C3-B24FA1274BD1}"/>
                </a:ext>
              </a:extLst>
            </p:cNvPr>
            <p:cNvGrpSpPr/>
            <p:nvPr/>
          </p:nvGrpSpPr>
          <p:grpSpPr>
            <a:xfrm>
              <a:off x="5101594" y="3132654"/>
              <a:ext cx="1050517" cy="276999"/>
              <a:chOff x="6410965" y="906702"/>
              <a:chExt cx="406430" cy="248063"/>
            </a:xfrm>
          </p:grpSpPr>
          <p:sp>
            <p:nvSpPr>
              <p:cNvPr id="56" name="Right Bracket 55">
                <a:extLst>
                  <a:ext uri="{FF2B5EF4-FFF2-40B4-BE49-F238E27FC236}">
                    <a16:creationId xmlns:a16="http://schemas.microsoft.com/office/drawing/2014/main" id="{DB985FF3-E65F-4572-AF7F-AAF94ED92462}"/>
                  </a:ext>
                </a:extLst>
              </p:cNvPr>
              <p:cNvSpPr/>
              <p:nvPr/>
            </p:nvSpPr>
            <p:spPr>
              <a:xfrm rot="16200000">
                <a:off x="6587627" y="872708"/>
                <a:ext cx="53105" cy="406430"/>
              </a:xfrm>
              <a:prstGeom prst="rightBracket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8F199FDE-5CB0-4CD3-B450-DBD0B45BCEEE}"/>
                  </a:ext>
                </a:extLst>
              </p:cNvPr>
              <p:cNvSpPr txBox="1"/>
              <p:nvPr/>
            </p:nvSpPr>
            <p:spPr>
              <a:xfrm>
                <a:off x="6544870" y="906702"/>
                <a:ext cx="209375" cy="2480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C5957EC-5186-4A9B-9FA5-3A5F2AE69A77}"/>
                </a:ext>
              </a:extLst>
            </p:cNvPr>
            <p:cNvGrpSpPr/>
            <p:nvPr/>
          </p:nvGrpSpPr>
          <p:grpSpPr>
            <a:xfrm>
              <a:off x="4085105" y="5358242"/>
              <a:ext cx="2832304" cy="1913369"/>
              <a:chOff x="6384680" y="549261"/>
              <a:chExt cx="2832304" cy="2400323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0E6E1DCC-BFB2-482D-968D-FA3D7AE536E7}"/>
                  </a:ext>
                </a:extLst>
              </p:cNvPr>
              <p:cNvSpPr txBox="1"/>
              <p:nvPr/>
            </p:nvSpPr>
            <p:spPr>
              <a:xfrm>
                <a:off x="6632272" y="549261"/>
                <a:ext cx="856325" cy="2770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CC1937</a:t>
                </a:r>
              </a:p>
            </p:txBody>
          </p:sp>
          <p:graphicFrame>
            <p:nvGraphicFramePr>
              <p:cNvPr id="58" name="Chart 57">
                <a:extLst>
                  <a:ext uri="{FF2B5EF4-FFF2-40B4-BE49-F238E27FC236}">
                    <a16:creationId xmlns:a16="http://schemas.microsoft.com/office/drawing/2014/main" id="{13EAFBC2-723B-4FBC-8BB0-7AFB6EBD095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23910729"/>
                  </p:ext>
                </p:extLst>
              </p:nvPr>
            </p:nvGraphicFramePr>
            <p:xfrm>
              <a:off x="6384680" y="796157"/>
              <a:ext cx="2832304" cy="215342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EEEDD5C7-E96C-4131-8110-88CB1E11A267}"/>
                  </a:ext>
                </a:extLst>
              </p:cNvPr>
              <p:cNvGrpSpPr/>
              <p:nvPr/>
            </p:nvGrpSpPr>
            <p:grpSpPr>
              <a:xfrm>
                <a:off x="7352227" y="804766"/>
                <a:ext cx="1108453" cy="276999"/>
                <a:chOff x="6410965" y="939600"/>
                <a:chExt cx="406430" cy="189210"/>
              </a:xfrm>
            </p:grpSpPr>
            <p:sp>
              <p:nvSpPr>
                <p:cNvPr id="60" name="Right Bracket 59">
                  <a:extLst>
                    <a:ext uri="{FF2B5EF4-FFF2-40B4-BE49-F238E27FC236}">
                      <a16:creationId xmlns:a16="http://schemas.microsoft.com/office/drawing/2014/main" id="{3FD50BC9-364C-43F7-B21D-E40DDB5B958F}"/>
                    </a:ext>
                  </a:extLst>
                </p:cNvPr>
                <p:cNvSpPr/>
                <p:nvPr/>
              </p:nvSpPr>
              <p:spPr>
                <a:xfrm rot="16200000">
                  <a:off x="6587627" y="872708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4259B29D-D0E2-430B-853B-90195A52939E}"/>
                    </a:ext>
                  </a:extLst>
                </p:cNvPr>
                <p:cNvSpPr txBox="1"/>
                <p:nvPr/>
              </p:nvSpPr>
              <p:spPr>
                <a:xfrm>
                  <a:off x="6559652" y="939600"/>
                  <a:ext cx="209375" cy="189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42374000-6491-4A29-A942-48022C3B3A3D}"/>
                  </a:ext>
                </a:extLst>
              </p:cNvPr>
              <p:cNvGrpSpPr/>
              <p:nvPr/>
            </p:nvGrpSpPr>
            <p:grpSpPr>
              <a:xfrm>
                <a:off x="7683090" y="906471"/>
                <a:ext cx="1050517" cy="276999"/>
                <a:chOff x="6410965" y="939600"/>
                <a:chExt cx="406430" cy="189210"/>
              </a:xfrm>
            </p:grpSpPr>
            <p:sp>
              <p:nvSpPr>
                <p:cNvPr id="63" name="Right Bracket 62">
                  <a:extLst>
                    <a:ext uri="{FF2B5EF4-FFF2-40B4-BE49-F238E27FC236}">
                      <a16:creationId xmlns:a16="http://schemas.microsoft.com/office/drawing/2014/main" id="{0872BDE2-67F2-4F69-A9BC-7639854D580B}"/>
                    </a:ext>
                  </a:extLst>
                </p:cNvPr>
                <p:cNvSpPr/>
                <p:nvPr/>
              </p:nvSpPr>
              <p:spPr>
                <a:xfrm rot="16200000">
                  <a:off x="6587627" y="872708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E7DF86B0-2565-429B-A6F2-18467F56799A}"/>
                    </a:ext>
                  </a:extLst>
                </p:cNvPr>
                <p:cNvSpPr txBox="1"/>
                <p:nvPr/>
              </p:nvSpPr>
              <p:spPr>
                <a:xfrm>
                  <a:off x="6559652" y="939600"/>
                  <a:ext cx="209375" cy="189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D5D5D5F3-239C-4DB1-BA66-3CDEF1D315C0}"/>
                </a:ext>
              </a:extLst>
            </p:cNvPr>
            <p:cNvSpPr txBox="1"/>
            <p:nvPr/>
          </p:nvSpPr>
          <p:spPr>
            <a:xfrm>
              <a:off x="804520" y="228600"/>
              <a:ext cx="4090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C3B0FF29-3184-4FF2-A145-FC1B4235B8AE}"/>
                </a:ext>
              </a:extLst>
            </p:cNvPr>
            <p:cNvGrpSpPr/>
            <p:nvPr/>
          </p:nvGrpSpPr>
          <p:grpSpPr>
            <a:xfrm>
              <a:off x="1204931" y="308287"/>
              <a:ext cx="2872920" cy="2215291"/>
              <a:chOff x="1220110" y="538145"/>
              <a:chExt cx="2872920" cy="1881062"/>
            </a:xfrm>
          </p:grpSpPr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FC06CF1B-AB9C-4EC0-AB64-9FB07826923B}"/>
                  </a:ext>
                </a:extLst>
              </p:cNvPr>
              <p:cNvSpPr txBox="1"/>
              <p:nvPr/>
            </p:nvSpPr>
            <p:spPr>
              <a:xfrm>
                <a:off x="1433383" y="538145"/>
                <a:ext cx="910827" cy="2205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CIS.com</a:t>
                </a:r>
              </a:p>
            </p:txBody>
          </p: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818FACEB-D5C2-47DF-95F9-766A267DD589}"/>
                  </a:ext>
                </a:extLst>
              </p:cNvPr>
              <p:cNvGrpSpPr/>
              <p:nvPr/>
            </p:nvGrpSpPr>
            <p:grpSpPr>
              <a:xfrm>
                <a:off x="1220110" y="807099"/>
                <a:ext cx="2872920" cy="1612108"/>
                <a:chOff x="1220110" y="807099"/>
                <a:chExt cx="2872920" cy="1612108"/>
              </a:xfrm>
            </p:grpSpPr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CDDACCB1-C844-4D7E-9169-E52BAD6EDD96}"/>
                    </a:ext>
                  </a:extLst>
                </p:cNvPr>
                <p:cNvSpPr txBox="1"/>
                <p:nvPr/>
              </p:nvSpPr>
              <p:spPr>
                <a:xfrm rot="16200000">
                  <a:off x="820578" y="1298789"/>
                  <a:ext cx="10760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wound closure</a:t>
                  </a:r>
                </a:p>
              </p:txBody>
            </p:sp>
            <p:graphicFrame>
              <p:nvGraphicFramePr>
                <p:cNvPr id="112" name="Chart 111">
                  <a:extLst>
                    <a:ext uri="{FF2B5EF4-FFF2-40B4-BE49-F238E27FC236}">
                      <a16:creationId xmlns:a16="http://schemas.microsoft.com/office/drawing/2014/main" id="{8E767D98-EBD9-4FC2-8162-0C78D56C5FE8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39584523"/>
                    </p:ext>
                  </p:extLst>
                </p:nvPr>
              </p:nvGraphicFramePr>
              <p:xfrm>
                <a:off x="1442959" y="807099"/>
                <a:ext cx="2650071" cy="161210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grpSp>
            <p:nvGrpSpPr>
              <p:cNvPr id="114" name="Group 113">
                <a:extLst>
                  <a:ext uri="{FF2B5EF4-FFF2-40B4-BE49-F238E27FC236}">
                    <a16:creationId xmlns:a16="http://schemas.microsoft.com/office/drawing/2014/main" id="{E200F2F9-67F8-4A69-A716-BDE1FC1761D0}"/>
                  </a:ext>
                </a:extLst>
              </p:cNvPr>
              <p:cNvGrpSpPr/>
              <p:nvPr/>
            </p:nvGrpSpPr>
            <p:grpSpPr>
              <a:xfrm>
                <a:off x="2601192" y="758739"/>
                <a:ext cx="1048620" cy="317220"/>
                <a:chOff x="6407738" y="1003729"/>
                <a:chExt cx="406430" cy="189210"/>
              </a:xfrm>
            </p:grpSpPr>
            <p:sp>
              <p:nvSpPr>
                <p:cNvPr id="115" name="Right Bracket 114">
                  <a:extLst>
                    <a:ext uri="{FF2B5EF4-FFF2-40B4-BE49-F238E27FC236}">
                      <a16:creationId xmlns:a16="http://schemas.microsoft.com/office/drawing/2014/main" id="{4661AB3E-3542-4172-9558-F8B65ABE9F9D}"/>
                    </a:ext>
                  </a:extLst>
                </p:cNvPr>
                <p:cNvSpPr/>
                <p:nvPr/>
              </p:nvSpPr>
              <p:spPr>
                <a:xfrm rot="16200000">
                  <a:off x="6584400" y="911171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0099B66E-D4A2-4DBC-8221-C9ABFA32652B}"/>
                    </a:ext>
                  </a:extLst>
                </p:cNvPr>
                <p:cNvSpPr txBox="1"/>
                <p:nvPr/>
              </p:nvSpPr>
              <p:spPr>
                <a:xfrm>
                  <a:off x="6553955" y="1003729"/>
                  <a:ext cx="209375" cy="189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714BFECC-7147-4EEA-AAE0-DB36BD7F766B}"/>
                  </a:ext>
                </a:extLst>
              </p:cNvPr>
              <p:cNvGrpSpPr/>
              <p:nvPr/>
            </p:nvGrpSpPr>
            <p:grpSpPr>
              <a:xfrm>
                <a:off x="2364189" y="616883"/>
                <a:ext cx="1076473" cy="304861"/>
                <a:chOff x="6407929" y="1001999"/>
                <a:chExt cx="406430" cy="189210"/>
              </a:xfrm>
            </p:grpSpPr>
            <p:sp>
              <p:nvSpPr>
                <p:cNvPr id="118" name="Right Bracket 117">
                  <a:extLst>
                    <a:ext uri="{FF2B5EF4-FFF2-40B4-BE49-F238E27FC236}">
                      <a16:creationId xmlns:a16="http://schemas.microsoft.com/office/drawing/2014/main" id="{B3AE1A89-879D-453B-B53D-E52494910D82}"/>
                    </a:ext>
                  </a:extLst>
                </p:cNvPr>
                <p:cNvSpPr/>
                <p:nvPr/>
              </p:nvSpPr>
              <p:spPr>
                <a:xfrm rot="16200000">
                  <a:off x="6584591" y="912789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0AAA63A2-3B10-46FA-8021-6DFC055F6517}"/>
                    </a:ext>
                  </a:extLst>
                </p:cNvPr>
                <p:cNvSpPr txBox="1"/>
                <p:nvPr/>
              </p:nvSpPr>
              <p:spPr>
                <a:xfrm>
                  <a:off x="6559601" y="1001999"/>
                  <a:ext cx="209375" cy="189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3FFD88C1-3AB2-4B7A-B9D4-A87520BA4C28}"/>
                </a:ext>
              </a:extLst>
            </p:cNvPr>
            <p:cNvGrpSpPr/>
            <p:nvPr/>
          </p:nvGrpSpPr>
          <p:grpSpPr>
            <a:xfrm>
              <a:off x="1106793" y="2943113"/>
              <a:ext cx="2921551" cy="2174927"/>
              <a:chOff x="3107709" y="3279943"/>
              <a:chExt cx="2921551" cy="2731942"/>
            </a:xfrm>
          </p:grpSpPr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C24FF52B-CD74-4859-9E86-9899BB0E93F1}"/>
                  </a:ext>
                </a:extLst>
              </p:cNvPr>
              <p:cNvSpPr txBox="1"/>
              <p:nvPr/>
            </p:nvSpPr>
            <p:spPr>
              <a:xfrm>
                <a:off x="3468592" y="3279943"/>
                <a:ext cx="9108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CIS.com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C730F779-7C3C-4DE4-AFFC-B620C2CB8A19}"/>
                  </a:ext>
                </a:extLst>
              </p:cNvPr>
              <p:cNvSpPr txBox="1"/>
              <p:nvPr/>
            </p:nvSpPr>
            <p:spPr>
              <a:xfrm rot="16200000">
                <a:off x="2467764" y="4275232"/>
                <a:ext cx="174155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PCNA expression</a:t>
                </a:r>
              </a:p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/DAPI</a:t>
                </a:r>
              </a:p>
            </p:txBody>
          </p:sp>
          <p:graphicFrame>
            <p:nvGraphicFramePr>
              <p:cNvPr id="120" name="Chart 119">
                <a:extLst>
                  <a:ext uri="{FF2B5EF4-FFF2-40B4-BE49-F238E27FC236}">
                    <a16:creationId xmlns:a16="http://schemas.microsoft.com/office/drawing/2014/main" id="{73A8471B-2C0C-456F-81D0-F28FFE20A3EE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69750575"/>
                  </p:ext>
                </p:extLst>
              </p:nvPr>
            </p:nvGraphicFramePr>
            <p:xfrm>
              <a:off x="3520408" y="3767633"/>
              <a:ext cx="2508852" cy="22442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grpSp>
            <p:nvGrpSpPr>
              <p:cNvPr id="121" name="Group 120">
                <a:extLst>
                  <a:ext uri="{FF2B5EF4-FFF2-40B4-BE49-F238E27FC236}">
                    <a16:creationId xmlns:a16="http://schemas.microsoft.com/office/drawing/2014/main" id="{2B6CC8D4-E9EC-4652-A35E-C8E02395489C}"/>
                  </a:ext>
                </a:extLst>
              </p:cNvPr>
              <p:cNvGrpSpPr/>
              <p:nvPr/>
            </p:nvGrpSpPr>
            <p:grpSpPr>
              <a:xfrm>
                <a:off x="4596644" y="3582549"/>
                <a:ext cx="1048620" cy="398462"/>
                <a:chOff x="6410965" y="939600"/>
                <a:chExt cx="406430" cy="189210"/>
              </a:xfrm>
            </p:grpSpPr>
            <p:sp>
              <p:nvSpPr>
                <p:cNvPr id="122" name="Right Bracket 121">
                  <a:extLst>
                    <a:ext uri="{FF2B5EF4-FFF2-40B4-BE49-F238E27FC236}">
                      <a16:creationId xmlns:a16="http://schemas.microsoft.com/office/drawing/2014/main" id="{14C3F43F-519C-4FC1-929D-E0228D0788F3}"/>
                    </a:ext>
                  </a:extLst>
                </p:cNvPr>
                <p:cNvSpPr/>
                <p:nvPr/>
              </p:nvSpPr>
              <p:spPr>
                <a:xfrm rot="16200000">
                  <a:off x="6587627" y="872708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AA21D182-9642-4D95-9DE8-2E47CA691BCD}"/>
                    </a:ext>
                  </a:extLst>
                </p:cNvPr>
                <p:cNvSpPr txBox="1"/>
                <p:nvPr/>
              </p:nvSpPr>
              <p:spPr>
                <a:xfrm>
                  <a:off x="6559652" y="939600"/>
                  <a:ext cx="209375" cy="189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124" name="Group 123">
                <a:extLst>
                  <a:ext uri="{FF2B5EF4-FFF2-40B4-BE49-F238E27FC236}">
                    <a16:creationId xmlns:a16="http://schemas.microsoft.com/office/drawing/2014/main" id="{09A3F68B-B0F6-4AE1-93F8-8976CAD747AD}"/>
                  </a:ext>
                </a:extLst>
              </p:cNvPr>
              <p:cNvGrpSpPr/>
              <p:nvPr/>
            </p:nvGrpSpPr>
            <p:grpSpPr>
              <a:xfrm>
                <a:off x="4359356" y="3413126"/>
                <a:ext cx="1076473" cy="329639"/>
                <a:chOff x="6410965" y="939600"/>
                <a:chExt cx="406430" cy="162875"/>
              </a:xfrm>
            </p:grpSpPr>
            <p:sp>
              <p:nvSpPr>
                <p:cNvPr id="125" name="Right Bracket 124">
                  <a:extLst>
                    <a:ext uri="{FF2B5EF4-FFF2-40B4-BE49-F238E27FC236}">
                      <a16:creationId xmlns:a16="http://schemas.microsoft.com/office/drawing/2014/main" id="{3CF9F57D-F307-4FEF-9CBE-A28141A37037}"/>
                    </a:ext>
                  </a:extLst>
                </p:cNvPr>
                <p:cNvSpPr/>
                <p:nvPr/>
              </p:nvSpPr>
              <p:spPr>
                <a:xfrm rot="16200000">
                  <a:off x="6587627" y="872708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E85E44D0-9F89-4EFC-A9AD-615AB7287CCE}"/>
                    </a:ext>
                  </a:extLst>
                </p:cNvPr>
                <p:cNvSpPr txBox="1"/>
                <p:nvPr/>
              </p:nvSpPr>
              <p:spPr>
                <a:xfrm>
                  <a:off x="6559652" y="939600"/>
                  <a:ext cx="209375" cy="1368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AB9AADAF-5E95-4519-BB5B-A6DD06DC28A8}"/>
                </a:ext>
              </a:extLst>
            </p:cNvPr>
            <p:cNvGrpSpPr/>
            <p:nvPr/>
          </p:nvGrpSpPr>
          <p:grpSpPr>
            <a:xfrm>
              <a:off x="921158" y="5257370"/>
              <a:ext cx="3107186" cy="2199296"/>
              <a:chOff x="5910538" y="3210061"/>
              <a:chExt cx="3107186" cy="2762552"/>
            </a:xfrm>
          </p:grpSpPr>
          <p:graphicFrame>
            <p:nvGraphicFramePr>
              <p:cNvPr id="129" name="Chart 128">
                <a:extLst>
                  <a:ext uri="{FF2B5EF4-FFF2-40B4-BE49-F238E27FC236}">
                    <a16:creationId xmlns:a16="http://schemas.microsoft.com/office/drawing/2014/main" id="{FCAE9E8C-2FEA-4476-9987-04B4D878B32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14991347"/>
                  </p:ext>
                </p:extLst>
              </p:nvPr>
            </p:nvGraphicFramePr>
            <p:xfrm>
              <a:off x="6442854" y="3518159"/>
              <a:ext cx="2574870" cy="245445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831E32DD-7BF6-40F2-835E-DB3CC79E4F4C}"/>
                  </a:ext>
                </a:extLst>
              </p:cNvPr>
              <p:cNvSpPr txBox="1"/>
              <p:nvPr/>
            </p:nvSpPr>
            <p:spPr>
              <a:xfrm>
                <a:off x="6648413" y="3210061"/>
                <a:ext cx="9108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CIS.com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03B578DF-DFE0-490A-9BD6-06D34B4FE55C}"/>
                  </a:ext>
                </a:extLst>
              </p:cNvPr>
              <p:cNvSpPr txBox="1"/>
              <p:nvPr/>
            </p:nvSpPr>
            <p:spPr>
              <a:xfrm rot="16200000" flipH="1">
                <a:off x="5174417" y="4202617"/>
                <a:ext cx="193390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caspase-3 expression/DAPI</a:t>
                </a:r>
              </a:p>
            </p:txBody>
          </p:sp>
          <p:grpSp>
            <p:nvGrpSpPr>
              <p:cNvPr id="130" name="Group 129">
                <a:extLst>
                  <a:ext uri="{FF2B5EF4-FFF2-40B4-BE49-F238E27FC236}">
                    <a16:creationId xmlns:a16="http://schemas.microsoft.com/office/drawing/2014/main" id="{4B380C2E-0F23-4CD8-82C2-3CE35389F0A2}"/>
                  </a:ext>
                </a:extLst>
              </p:cNvPr>
              <p:cNvGrpSpPr/>
              <p:nvPr/>
            </p:nvGrpSpPr>
            <p:grpSpPr>
              <a:xfrm>
                <a:off x="7395321" y="3533998"/>
                <a:ext cx="1048620" cy="398462"/>
                <a:chOff x="6412255" y="1015162"/>
                <a:chExt cx="406430" cy="189210"/>
              </a:xfrm>
            </p:grpSpPr>
            <p:sp>
              <p:nvSpPr>
                <p:cNvPr id="131" name="Right Bracket 130">
                  <a:extLst>
                    <a:ext uri="{FF2B5EF4-FFF2-40B4-BE49-F238E27FC236}">
                      <a16:creationId xmlns:a16="http://schemas.microsoft.com/office/drawing/2014/main" id="{0EAFBD28-1BD2-4CD4-9114-8B3EA3DFA900}"/>
                    </a:ext>
                  </a:extLst>
                </p:cNvPr>
                <p:cNvSpPr/>
                <p:nvPr/>
              </p:nvSpPr>
              <p:spPr>
                <a:xfrm rot="16200000">
                  <a:off x="6588917" y="953981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TextBox 131">
                  <a:extLst>
                    <a:ext uri="{FF2B5EF4-FFF2-40B4-BE49-F238E27FC236}">
                      <a16:creationId xmlns:a16="http://schemas.microsoft.com/office/drawing/2014/main" id="{1AA16A59-056E-48E8-950E-4B769384A1DC}"/>
                    </a:ext>
                  </a:extLst>
                </p:cNvPr>
                <p:cNvSpPr txBox="1"/>
                <p:nvPr/>
              </p:nvSpPr>
              <p:spPr>
                <a:xfrm>
                  <a:off x="6546478" y="1015162"/>
                  <a:ext cx="209375" cy="1892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</p:grpSp>
          <p:grpSp>
            <p:nvGrpSpPr>
              <p:cNvPr id="133" name="Group 132">
                <a:extLst>
                  <a:ext uri="{FF2B5EF4-FFF2-40B4-BE49-F238E27FC236}">
                    <a16:creationId xmlns:a16="http://schemas.microsoft.com/office/drawing/2014/main" id="{187CB952-80E2-44A5-8CF2-9C2E29930548}"/>
                  </a:ext>
                </a:extLst>
              </p:cNvPr>
              <p:cNvGrpSpPr/>
              <p:nvPr/>
            </p:nvGrpSpPr>
            <p:grpSpPr>
              <a:xfrm>
                <a:off x="7642578" y="3762213"/>
                <a:ext cx="1048620" cy="308852"/>
                <a:chOff x="6447849" y="1005436"/>
                <a:chExt cx="406430" cy="146659"/>
              </a:xfrm>
            </p:grpSpPr>
            <p:sp>
              <p:nvSpPr>
                <p:cNvPr id="134" name="Right Bracket 133">
                  <a:extLst>
                    <a:ext uri="{FF2B5EF4-FFF2-40B4-BE49-F238E27FC236}">
                      <a16:creationId xmlns:a16="http://schemas.microsoft.com/office/drawing/2014/main" id="{AECE452C-74C1-4EEA-A2D8-5356469C1276}"/>
                    </a:ext>
                  </a:extLst>
                </p:cNvPr>
                <p:cNvSpPr/>
                <p:nvPr/>
              </p:nvSpPr>
              <p:spPr>
                <a:xfrm rot="16200000">
                  <a:off x="6624511" y="922328"/>
                  <a:ext cx="53105" cy="406430"/>
                </a:xfrm>
                <a:prstGeom prst="rightBracket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TextBox 134">
                  <a:extLst>
                    <a:ext uri="{FF2B5EF4-FFF2-40B4-BE49-F238E27FC236}">
                      <a16:creationId xmlns:a16="http://schemas.microsoft.com/office/drawing/2014/main" id="{B2C5A7DB-FCD9-4B0A-9068-FA32C59E0419}"/>
                    </a:ext>
                  </a:extLst>
                </p:cNvPr>
                <p:cNvSpPr txBox="1"/>
                <p:nvPr/>
              </p:nvSpPr>
              <p:spPr>
                <a:xfrm>
                  <a:off x="6595895" y="1005436"/>
                  <a:ext cx="209375" cy="131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</p:grp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5203D51B-62F7-44AE-885E-F3240BE41635}"/>
                </a:ext>
              </a:extLst>
            </p:cNvPr>
            <p:cNvSpPr txBox="1"/>
            <p:nvPr/>
          </p:nvSpPr>
          <p:spPr>
            <a:xfrm>
              <a:off x="804520" y="5187440"/>
              <a:ext cx="4090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A6CF2058-623B-407C-B703-A7A4990F0357}"/>
                </a:ext>
              </a:extLst>
            </p:cNvPr>
            <p:cNvSpPr txBox="1"/>
            <p:nvPr/>
          </p:nvSpPr>
          <p:spPr>
            <a:xfrm>
              <a:off x="804520" y="2653353"/>
              <a:ext cx="458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96263396-88AD-4082-B161-32E56C0C40A1}"/>
                </a:ext>
              </a:extLst>
            </p:cNvPr>
            <p:cNvGrpSpPr/>
            <p:nvPr/>
          </p:nvGrpSpPr>
          <p:grpSpPr>
            <a:xfrm>
              <a:off x="921160" y="7612205"/>
              <a:ext cx="3496559" cy="2112272"/>
              <a:chOff x="1820212" y="2661741"/>
              <a:chExt cx="5190188" cy="2824659"/>
            </a:xfrm>
          </p:grpSpPr>
          <p:graphicFrame>
            <p:nvGraphicFramePr>
              <p:cNvPr id="105" name="Chart 104">
                <a:extLst>
                  <a:ext uri="{FF2B5EF4-FFF2-40B4-BE49-F238E27FC236}">
                    <a16:creationId xmlns:a16="http://schemas.microsoft.com/office/drawing/2014/main" id="{BF19D981-F722-4E57-9B63-82637DD5FFC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90361836"/>
                  </p:ext>
                </p:extLst>
              </p:nvPr>
            </p:nvGraphicFramePr>
            <p:xfrm>
              <a:off x="2438400" y="27432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pSp>
            <p:nvGrpSpPr>
              <p:cNvPr id="106" name="Group 105">
                <a:extLst>
                  <a:ext uri="{FF2B5EF4-FFF2-40B4-BE49-F238E27FC236}">
                    <a16:creationId xmlns:a16="http://schemas.microsoft.com/office/drawing/2014/main" id="{71E61A82-C779-4671-8ECC-079E09A79D70}"/>
                  </a:ext>
                </a:extLst>
              </p:cNvPr>
              <p:cNvGrpSpPr/>
              <p:nvPr/>
            </p:nvGrpSpPr>
            <p:grpSpPr>
              <a:xfrm>
                <a:off x="4618989" y="2661741"/>
                <a:ext cx="2100370" cy="545693"/>
                <a:chOff x="7936695" y="2122465"/>
                <a:chExt cx="962014" cy="545693"/>
              </a:xfrm>
            </p:grpSpPr>
            <p:cxnSp>
              <p:nvCxnSpPr>
                <p:cNvPr id="108" name="Straight Connector 107">
                  <a:extLst>
                    <a:ext uri="{FF2B5EF4-FFF2-40B4-BE49-F238E27FC236}">
                      <a16:creationId xmlns:a16="http://schemas.microsoft.com/office/drawing/2014/main" id="{C05AF231-1C8F-4035-B556-7DCEDDF0A9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36695" y="2338898"/>
                  <a:ext cx="36576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43456655-675C-4884-BA24-A69F5384F32E}"/>
                    </a:ext>
                  </a:extLst>
                </p:cNvPr>
                <p:cNvSpPr txBox="1"/>
                <p:nvPr/>
              </p:nvSpPr>
              <p:spPr>
                <a:xfrm>
                  <a:off x="7962505" y="2122465"/>
                  <a:ext cx="45264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***</a:t>
                  </a:r>
                </a:p>
              </p:txBody>
            </p:sp>
            <p:cxnSp>
              <p:nvCxnSpPr>
                <p:cNvPr id="110" name="Straight Connector 109">
                  <a:extLst>
                    <a:ext uri="{FF2B5EF4-FFF2-40B4-BE49-F238E27FC236}">
                      <a16:creationId xmlns:a16="http://schemas.microsoft.com/office/drawing/2014/main" id="{5FD1EF9F-D830-41F5-815A-2750879F780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530315" y="2555113"/>
                  <a:ext cx="365760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62BB3808-6D24-4D47-A0AC-86B3F07D7B4B}"/>
                    </a:ext>
                  </a:extLst>
                </p:cNvPr>
                <p:cNvSpPr txBox="1"/>
                <p:nvPr/>
              </p:nvSpPr>
              <p:spPr>
                <a:xfrm>
                  <a:off x="8571079" y="2338898"/>
                  <a:ext cx="327630" cy="32926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/>
                    <a:t>***</a:t>
                  </a:r>
                </a:p>
              </p:txBody>
            </p:sp>
          </p:grp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BE2A633B-3D88-45AF-AEA2-ABC6FDD225D6}"/>
                  </a:ext>
                </a:extLst>
              </p:cNvPr>
              <p:cNvSpPr txBox="1"/>
              <p:nvPr/>
            </p:nvSpPr>
            <p:spPr>
              <a:xfrm rot="16200000">
                <a:off x="1301013" y="3304048"/>
                <a:ext cx="1723679" cy="6852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ean spheroid size (microns²)</a:t>
                </a:r>
              </a:p>
            </p:txBody>
          </p:sp>
        </p:grp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EA559E6D-381E-412F-8035-0321C4FDD884}"/>
                </a:ext>
              </a:extLst>
            </p:cNvPr>
            <p:cNvSpPr txBox="1"/>
            <p:nvPr/>
          </p:nvSpPr>
          <p:spPr>
            <a:xfrm>
              <a:off x="804520" y="7414173"/>
              <a:ext cx="4090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03020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69DD23D0-69F5-4B3F-8E4E-ECB063DF96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5016371"/>
              </p:ext>
            </p:extLst>
          </p:nvPr>
        </p:nvGraphicFramePr>
        <p:xfrm>
          <a:off x="2895600" y="5257800"/>
          <a:ext cx="3596067" cy="2164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A798BA88-68A0-4C84-8EC4-54B1F8D2FEF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2769708"/>
              </p:ext>
            </p:extLst>
          </p:nvPr>
        </p:nvGraphicFramePr>
        <p:xfrm>
          <a:off x="2987375" y="1887900"/>
          <a:ext cx="3596067" cy="21642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F925C51-83F3-4045-87E8-B4E8578C0D09}"/>
              </a:ext>
            </a:extLst>
          </p:cNvPr>
          <p:cNvSpPr txBox="1"/>
          <p:nvPr/>
        </p:nvSpPr>
        <p:spPr>
          <a:xfrm rot="16200000">
            <a:off x="1786978" y="2720220"/>
            <a:ext cx="20617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ucose consumption (mM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8D72CA-B7BD-4856-B449-A5710B01D4B1}"/>
              </a:ext>
            </a:extLst>
          </p:cNvPr>
          <p:cNvSpPr txBox="1"/>
          <p:nvPr/>
        </p:nvSpPr>
        <p:spPr>
          <a:xfrm rot="16200000">
            <a:off x="1720004" y="6201424"/>
            <a:ext cx="20617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ucose consumption (mM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2D3244C-CC3D-4064-90A7-C1CE81AB29BF}"/>
              </a:ext>
            </a:extLst>
          </p:cNvPr>
          <p:cNvSpPr txBox="1"/>
          <p:nvPr/>
        </p:nvSpPr>
        <p:spPr>
          <a:xfrm>
            <a:off x="2394405" y="8057191"/>
            <a:ext cx="4681575" cy="26174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80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 Effects of CCL2 on glucose consumption in breast cancer cells. in 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CIS.com and HCC1937 cells or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M225 pHAGE control or CCR2 overexpressing (CCR2-H) were treated with 100 ng/ml CCL2 for 24 hours and analyzed for glucose consumption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tatistical analysis was performed by two tailed t-test (A) or ONE-WAY ANOVA with Bonferroni post-hoc comparison (B). 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 significance was determined by *p&lt;0.05. *p&lt;0.05. Mean ± SEM are shown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+mn-ea"/>
              </a:rPr>
              <a:t> 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amples were plated in triplicate and experiments were performed three times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endParaRPr lang="en-US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831032E-0EDC-4668-8824-6ACC2A4C39CC}"/>
              </a:ext>
            </a:extLst>
          </p:cNvPr>
          <p:cNvSpPr txBox="1"/>
          <p:nvPr/>
        </p:nvSpPr>
        <p:spPr>
          <a:xfrm>
            <a:off x="2407852" y="1654415"/>
            <a:ext cx="409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C08B86-5F14-4393-AD3D-EA834B7FEFBE}"/>
              </a:ext>
            </a:extLst>
          </p:cNvPr>
          <p:cNvSpPr txBox="1"/>
          <p:nvPr/>
        </p:nvSpPr>
        <p:spPr>
          <a:xfrm>
            <a:off x="2430470" y="4962208"/>
            <a:ext cx="4589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48CD09D-2442-43F6-B096-2D5940CEAF7C}"/>
              </a:ext>
            </a:extLst>
          </p:cNvPr>
          <p:cNvSpPr txBox="1"/>
          <p:nvPr/>
        </p:nvSpPr>
        <p:spPr>
          <a:xfrm>
            <a:off x="3592387" y="7323958"/>
            <a:ext cx="18902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HAG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   CCR2-H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3832B60D-A0E6-4A7A-BB3C-9CCD53565489}"/>
              </a:ext>
            </a:extLst>
          </p:cNvPr>
          <p:cNvGrpSpPr/>
          <p:nvPr/>
        </p:nvGrpSpPr>
        <p:grpSpPr>
          <a:xfrm>
            <a:off x="4032672" y="5220091"/>
            <a:ext cx="1164310" cy="243757"/>
            <a:chOff x="6410965" y="939600"/>
            <a:chExt cx="406430" cy="189210"/>
          </a:xfrm>
        </p:grpSpPr>
        <p:sp>
          <p:nvSpPr>
            <p:cNvPr id="14" name="Right Bracket 13">
              <a:extLst>
                <a:ext uri="{FF2B5EF4-FFF2-40B4-BE49-F238E27FC236}">
                  <a16:creationId xmlns:a16="http://schemas.microsoft.com/office/drawing/2014/main" id="{7637A97E-5075-4022-AE37-C20AB2588188}"/>
                </a:ext>
              </a:extLst>
            </p:cNvPr>
            <p:cNvSpPr/>
            <p:nvPr/>
          </p:nvSpPr>
          <p:spPr>
            <a:xfrm rot="16200000">
              <a:off x="6587627" y="872708"/>
              <a:ext cx="53105" cy="406430"/>
            </a:xfrm>
            <a:prstGeom prst="rightBracket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E1138E8-43C9-4C08-A9F5-CE4CCFA4BE7D}"/>
                </a:ext>
              </a:extLst>
            </p:cNvPr>
            <p:cNvSpPr txBox="1"/>
            <p:nvPr/>
          </p:nvSpPr>
          <p:spPr>
            <a:xfrm>
              <a:off x="6559652" y="939600"/>
              <a:ext cx="98866" cy="1892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521994A5-C2DA-4707-996D-2C08D21DCF1B}"/>
              </a:ext>
            </a:extLst>
          </p:cNvPr>
          <p:cNvSpPr txBox="1"/>
          <p:nvPr/>
        </p:nvSpPr>
        <p:spPr>
          <a:xfrm>
            <a:off x="5196981" y="1854708"/>
            <a:ext cx="283224" cy="243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43D409F-078E-4085-85EA-275D2364DF8A}"/>
              </a:ext>
            </a:extLst>
          </p:cNvPr>
          <p:cNvSpPr txBox="1"/>
          <p:nvPr/>
        </p:nvSpPr>
        <p:spPr>
          <a:xfrm>
            <a:off x="4032670" y="2826085"/>
            <a:ext cx="283224" cy="2437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285120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851201CF-5124-4910-9F5B-B324A861B4E9}"/>
              </a:ext>
            </a:extLst>
          </p:cNvPr>
          <p:cNvSpPr txBox="1"/>
          <p:nvPr/>
        </p:nvSpPr>
        <p:spPr>
          <a:xfrm>
            <a:off x="3808649" y="2998591"/>
            <a:ext cx="763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CR2-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3A546EB-0D59-4187-A01A-52722DFECE36}"/>
              </a:ext>
            </a:extLst>
          </p:cNvPr>
          <p:cNvSpPr txBox="1"/>
          <p:nvPr/>
        </p:nvSpPr>
        <p:spPr>
          <a:xfrm>
            <a:off x="1921368" y="2971800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HAG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80B9AC1-A678-4B71-931D-19846EA1092E}"/>
              </a:ext>
            </a:extLst>
          </p:cNvPr>
          <p:cNvSpPr txBox="1"/>
          <p:nvPr/>
        </p:nvSpPr>
        <p:spPr>
          <a:xfrm rot="5400000">
            <a:off x="4592580" y="3971926"/>
            <a:ext cx="1638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Y1234/5 MET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7AAE70A-0E71-4DBC-ABAD-AFF42ABCE946}"/>
              </a:ext>
            </a:extLst>
          </p:cNvPr>
          <p:cNvSpPr txBox="1"/>
          <p:nvPr/>
        </p:nvSpPr>
        <p:spPr>
          <a:xfrm rot="5400000">
            <a:off x="4592580" y="5739335"/>
            <a:ext cx="16380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Y1349 MET</a:t>
            </a:r>
          </a:p>
        </p:txBody>
      </p:sp>
      <p:pic>
        <p:nvPicPr>
          <p:cNvPr id="50" name="Picture 49" descr="A picture containing fabric, porcelain&#10;&#10;Description automatically generated">
            <a:extLst>
              <a:ext uri="{FF2B5EF4-FFF2-40B4-BE49-F238E27FC236}">
                <a16:creationId xmlns:a16="http://schemas.microsoft.com/office/drawing/2014/main" id="{6CF2065D-5313-4E48-9996-22CE4C43B2FD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6019" y="3287465"/>
            <a:ext cx="1920240" cy="164592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F4F223A6-E77E-4519-80D4-51B327576FB2}"/>
              </a:ext>
            </a:extLst>
          </p:cNvPr>
          <p:cNvSpPr txBox="1"/>
          <p:nvPr/>
        </p:nvSpPr>
        <p:spPr>
          <a:xfrm>
            <a:off x="5819253" y="2982179"/>
            <a:ext cx="1709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ti-rabbit-biotinylate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51A867D-06A9-4959-B76D-F18A909C3B16}"/>
              </a:ext>
            </a:extLst>
          </p:cNvPr>
          <p:cNvSpPr txBox="1"/>
          <p:nvPr/>
        </p:nvSpPr>
        <p:spPr>
          <a:xfrm>
            <a:off x="1250570" y="6807845"/>
            <a:ext cx="66428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 CCR2 overexpression in SUM225 breast lesions enhances CCL2-induced MET phosphorylation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M225 control phage cells or CCR2 overexpressing breast lesions (CCR2-H) (n=7/group) were immunostained for expression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hosporylat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ET. Representative images are shown. Scale bar=200 microns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22490C29-3E6C-4E5E-9396-39EB512608E1}"/>
              </a:ext>
            </a:extLst>
          </p:cNvPr>
          <p:cNvGrpSpPr/>
          <p:nvPr/>
        </p:nvGrpSpPr>
        <p:grpSpPr>
          <a:xfrm>
            <a:off x="1297286" y="3287465"/>
            <a:ext cx="1920240" cy="1645920"/>
            <a:chOff x="1158516" y="1775089"/>
            <a:chExt cx="1920240" cy="1645920"/>
          </a:xfrm>
        </p:grpSpPr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B5B9AEA0-E4F0-4922-970D-3F16DCACC68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8516" y="1775089"/>
              <a:ext cx="1920240" cy="16459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DE54EA71-F54D-4240-82E9-AEC2CDE92AE2}"/>
                </a:ext>
              </a:extLst>
            </p:cNvPr>
            <p:cNvCxnSpPr>
              <a:cxnSpLocks/>
            </p:cNvCxnSpPr>
            <p:nvPr/>
          </p:nvCxnSpPr>
          <p:spPr>
            <a:xfrm>
              <a:off x="2488240" y="3353432"/>
              <a:ext cx="493776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5B7C229-737E-40B3-9FEE-CBDC35C5739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0016311"/>
              </p:ext>
            </p:extLst>
          </p:nvPr>
        </p:nvGraphicFramePr>
        <p:xfrm>
          <a:off x="5716019" y="5054874"/>
          <a:ext cx="1920240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r:id="rId5" imgW="4545720" imgH="3339360" progId="">
                  <p:embed/>
                </p:oleObj>
              </mc:Choice>
              <mc:Fallback>
                <p:oleObj r:id="rId5" imgW="4545720" imgH="3339360" progId="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16019" y="5054874"/>
                        <a:ext cx="1920240" cy="164592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 descr="A close-up of some petroglyphs&#10;&#10;Description automatically generated with medium confidence">
            <a:extLst>
              <a:ext uri="{FF2B5EF4-FFF2-40B4-BE49-F238E27FC236}">
                <a16:creationId xmlns:a16="http://schemas.microsoft.com/office/drawing/2014/main" id="{08C9573C-099C-4350-9B8A-BD4C954A62FA}"/>
              </a:ext>
            </a:extLst>
          </p:cNvPr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2070" y="5050302"/>
            <a:ext cx="1920240" cy="1645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33A8D18-40EA-46C4-BC6B-B416E7C7B061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7286" y="5054874"/>
            <a:ext cx="1920240" cy="1645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Picture 24" descr="A picture containing chocolate&#10;&#10;Description automatically generated">
            <a:extLst>
              <a:ext uri="{FF2B5EF4-FFF2-40B4-BE49-F238E27FC236}">
                <a16:creationId xmlns:a16="http://schemas.microsoft.com/office/drawing/2014/main" id="{3E416CF0-DD4B-49C6-93A8-FD744E9E5DA0}"/>
              </a:ext>
            </a:extLst>
          </p:cNvPr>
          <p:cNvPicPr preferRelativeResize="0"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3818" y="3287465"/>
            <a:ext cx="1920240" cy="164592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638266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582</TotalTime>
  <Words>662</Words>
  <Application>Microsoft Office PowerPoint</Application>
  <PresentationFormat>Custom</PresentationFormat>
  <Paragraphs>65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Kansas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Nikki Cheng</cp:lastModifiedBy>
  <cp:revision>1916</cp:revision>
  <cp:lastPrinted>2021-01-23T23:09:49Z</cp:lastPrinted>
  <dcterms:created xsi:type="dcterms:W3CDTF">2015-06-24T21:45:30Z</dcterms:created>
  <dcterms:modified xsi:type="dcterms:W3CDTF">2022-01-05T19:00:21Z</dcterms:modified>
</cp:coreProperties>
</file>